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950" r:id="rId2"/>
    <p:sldId id="951" r:id="rId3"/>
    <p:sldId id="932" r:id="rId4"/>
    <p:sldId id="939" r:id="rId5"/>
    <p:sldId id="942" r:id="rId6"/>
    <p:sldId id="944" r:id="rId7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DD7EE"/>
    <a:srgbClr val="FF7C80"/>
    <a:srgbClr val="FF3300"/>
    <a:srgbClr val="377DB8"/>
    <a:srgbClr val="E51A1D"/>
    <a:srgbClr val="E41A1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75" autoAdjust="0"/>
    <p:restoredTop sz="79865" autoAdjust="0"/>
  </p:normalViewPr>
  <p:slideViewPr>
    <p:cSldViewPr snapToGrid="0">
      <p:cViewPr varScale="1">
        <p:scale>
          <a:sx n="53" d="100"/>
          <a:sy n="53" d="100"/>
        </p:scale>
        <p:origin x="11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18830" cy="495029"/>
          </a:xfrm>
          <a:prstGeom prst="rect">
            <a:avLst/>
          </a:prstGeom>
        </p:spPr>
        <p:txBody>
          <a:bodyPr vert="horz" lIns="90749" tIns="45375" rIns="90749" bIns="4537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6" y="0"/>
            <a:ext cx="2918830" cy="495029"/>
          </a:xfrm>
          <a:prstGeom prst="rect">
            <a:avLst/>
          </a:prstGeom>
        </p:spPr>
        <p:txBody>
          <a:bodyPr vert="horz" lIns="90749" tIns="45375" rIns="90749" bIns="45375" rtlCol="0"/>
          <a:lstStyle>
            <a:lvl1pPr algn="r">
              <a:defRPr sz="1200"/>
            </a:lvl1pPr>
          </a:lstStyle>
          <a:p>
            <a:fld id="{8BF1CA9B-DE81-424E-B773-C8C5ED0A2D84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749" tIns="45375" rIns="90749" bIns="4537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4"/>
            <a:ext cx="5388610" cy="3884861"/>
          </a:xfrm>
          <a:prstGeom prst="rect">
            <a:avLst/>
          </a:prstGeom>
        </p:spPr>
        <p:txBody>
          <a:bodyPr vert="horz" lIns="90749" tIns="45375" rIns="90749" bIns="45375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371286"/>
            <a:ext cx="2918830" cy="495028"/>
          </a:xfrm>
          <a:prstGeom prst="rect">
            <a:avLst/>
          </a:prstGeom>
        </p:spPr>
        <p:txBody>
          <a:bodyPr vert="horz" lIns="90749" tIns="45375" rIns="90749" bIns="4537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6" y="9371286"/>
            <a:ext cx="2918830" cy="495028"/>
          </a:xfrm>
          <a:prstGeom prst="rect">
            <a:avLst/>
          </a:prstGeom>
        </p:spPr>
        <p:txBody>
          <a:bodyPr vert="horz" lIns="90749" tIns="45375" rIns="90749" bIns="45375" rtlCol="0" anchor="b"/>
          <a:lstStyle>
            <a:lvl1pPr algn="r">
              <a:defRPr sz="1200"/>
            </a:lvl1pPr>
          </a:lstStyle>
          <a:p>
            <a:fld id="{42AFA940-A743-497F-BAAE-27EA55C77E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15097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AFA940-A743-497F-BAAE-27EA55C77EE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7176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AFA940-A743-497F-BAAE-27EA55C77EE1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9386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07493">
              <a:defRPr/>
            </a:pPr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AFA940-A743-497F-BAAE-27EA55C77EE1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85611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AFA940-A743-497F-BAAE-27EA55C77EE1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556246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AFA940-A743-497F-BAAE-27EA55C77EE1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581739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AFA940-A743-497F-BAAE-27EA55C77EE1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2598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D7A8E9-A74E-44F5-AFD8-B1AD6F3DA6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51783A5-2A2E-4C59-8A82-E9D7B50B96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7FF0817-E12A-49D3-94D1-F747D14A2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EB768-07A2-401D-A57B-2E51C748AD32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C1AB386-E141-4439-9A68-00151AEAB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DB1184-0894-4FED-829C-3418496D8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CAD7F-30E0-4D67-874C-12DABC9D08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0192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C1286D-A009-496A-9D9F-EF49995025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407F5D4-DE2F-49F1-984F-9CC3B6986D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F3FF22-0F09-4818-855A-9D396D322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EB768-07A2-401D-A57B-2E51C748AD32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C1F7EFE-FC9B-442D-AA71-3688AAE47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B7D703D-4DA6-4B47-B0E0-21CB801B7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CAD7F-30E0-4D67-874C-12DABC9D08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8036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C06B4F1-3275-44D7-9BC7-DF95950205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42E8FCA-C383-4927-9932-E4DBA48CB9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54824ED-EFCB-4BD1-AF1A-B5D7EA8F91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EB768-07A2-401D-A57B-2E51C748AD32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72A480B-DBC4-4FDC-BFEF-E686B9BC4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65F0A6E-D6D0-4F7E-BA27-B046D9F692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CAD7F-30E0-4D67-874C-12DABC9D08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4214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EA354B-B1FA-49F4-ABF2-CADDC74560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8C14F16-BCBD-4B49-853E-D0189AF924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6215D0-1577-4C81-B031-BC633B17FF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EB768-07A2-401D-A57B-2E51C748AD32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567E21-5C11-4E44-A6AB-ECE2321E6F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07D70E-07C2-4BE9-B578-173EB5E91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CAD7F-30E0-4D67-874C-12DABC9D08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2626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1038C8-C329-4E58-9E14-1709AD45EF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97FDEFE-2DA8-4D77-8266-745EE5C592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8A2DA62-659C-4B17-A4D3-3702A78F7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EB768-07A2-401D-A57B-2E51C748AD32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506D80-D3F1-4D0A-BA63-D5FD312FE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0B7DA5E-FBF7-4E32-B96F-67E86A962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CAD7F-30E0-4D67-874C-12DABC9D08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2212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AF131A-9B29-42A9-959F-2A1EC7898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26E2A79-D08E-447C-8A4D-E6DFB9CA94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2AFA1CD-D3DD-4B78-B10A-B14AFBACD1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B587348-ACBF-4D88-9C26-710F96D72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EB768-07A2-401D-A57B-2E51C748AD32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41815D3-041D-4C68-9AB8-45C0C1D22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455883D-ED34-4B2F-9350-EFF3F1DF2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CAD7F-30E0-4D67-874C-12DABC9D08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847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72924A-3F73-4D09-8A9F-8484BE60A4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FB84AAF-0144-4537-BEE7-2540F3B896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BD0D9D2-DF38-42EC-A0C9-A32BA6E44D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F42A40C-3E00-480E-9DB3-F18299C02C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06BBF6C-D79F-4D91-B07B-00DED0543C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358EA48-4F02-46E0-AE96-00E42D82D5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EB768-07A2-401D-A57B-2E51C748AD32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83EBC7B-F5A7-4B19-A768-19C4E921E7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1D1B8FB-BADD-4481-B957-01FCB7F888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CAD7F-30E0-4D67-874C-12DABC9D08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7195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6E11E4-788E-4B45-8D5F-4B0820A635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6328AB9-A0D8-475C-BC27-9002D8207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EB768-07A2-401D-A57B-2E51C748AD32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58436B9-EFFF-4926-A461-83EAE04AEC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88CE88E-72A8-46F6-BB00-5474B6E7C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CAD7F-30E0-4D67-874C-12DABC9D08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70865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0C7CAE1-2A9B-4AD6-BFD1-B0DE9E29D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EB768-07A2-401D-A57B-2E51C748AD32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63AC699-FAEC-4473-AFD8-EB82E9C66A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2C3C6EB-8308-474B-81EA-3E8502454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CAD7F-30E0-4D67-874C-12DABC9D08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3482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75A471-DCE9-4A1A-B237-472D0E6222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606E32C-A2D0-45AC-97E0-48962235A9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1FE5C50-883D-4B54-99E0-F71F8B5886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449DF6F-BB8D-4C63-95EF-71292B0B0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EB768-07A2-401D-A57B-2E51C748AD32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555316F-169D-4B20-8F78-9E9F9AEFE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6A05FBF-46C4-4B65-99C2-6C44862EC4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CAD7F-30E0-4D67-874C-12DABC9D08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7998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161AD7-46A2-492C-A2B1-A1F817F1FF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376F045-B490-4D00-A7AF-231665655C5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4E32854-31B8-40FB-808E-69DFFB8A42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1BE0C93-57E3-4ECD-B02C-38903F94E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EB768-07A2-401D-A57B-2E51C748AD32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922125E-B55D-48A9-A495-DCECB2A057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C1CC645-B468-4691-ACB3-4E92D9C578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CAD7F-30E0-4D67-874C-12DABC9D08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8797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D495FC7-FADA-4F7F-808D-F5D153DDB0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EB24069-4D09-4E04-AF04-45CB743628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3471DA-9187-4577-841B-4D46045EF6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DEB768-07A2-401D-A57B-2E51C748AD32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3FCC948-02FF-4CD4-865F-9E0552B321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813AB7-042F-4782-B585-FC32ADF443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CAD7F-30E0-4D67-874C-12DABC9D08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055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>
            <a:extLst>
              <a:ext uri="{FF2B5EF4-FFF2-40B4-BE49-F238E27FC236}">
                <a16:creationId xmlns:a16="http://schemas.microsoft.com/office/drawing/2014/main" id="{2B14876E-4788-3CAD-CAB2-74808742142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5269"/>
          <a:stretch/>
        </p:blipFill>
        <p:spPr>
          <a:xfrm>
            <a:off x="8100000" y="1872000"/>
            <a:ext cx="3976385" cy="310531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BDD3F13E-6932-7DDA-479E-6BDE28C330A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36073" y="1876345"/>
            <a:ext cx="4197566" cy="310531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7F46FCD1-2333-B7B5-0BE8-971522E8E03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2143" y="1876345"/>
            <a:ext cx="4197566" cy="310531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52B4857-F691-4CB0-89E9-18D60CA78F33}"/>
              </a:ext>
            </a:extLst>
          </p:cNvPr>
          <p:cNvSpPr txBox="1"/>
          <p:nvPr/>
        </p:nvSpPr>
        <p:spPr>
          <a:xfrm>
            <a:off x="1798689" y="1404000"/>
            <a:ext cx="966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566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8F1DE8D2-5A7B-4AB6-8AFE-E1FF5528E454}"/>
              </a:ext>
            </a:extLst>
          </p:cNvPr>
          <p:cNvGrpSpPr/>
          <p:nvPr/>
        </p:nvGrpSpPr>
        <p:grpSpPr>
          <a:xfrm>
            <a:off x="1476000" y="1728000"/>
            <a:ext cx="1548000" cy="144000"/>
            <a:chOff x="1258295" y="314764"/>
            <a:chExt cx="1548000" cy="144000"/>
          </a:xfrm>
        </p:grpSpPr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27C90679-FBEA-4BC8-9AB2-8CC6F9020C16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E166DF4B-A54B-4E2F-844F-4B078F3A1148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FB4CE9E6-8872-456E-AC7D-F2150FDDDC19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89A8E384-3665-4DDF-AAC6-BDC2CE7A735E}"/>
              </a:ext>
            </a:extLst>
          </p:cNvPr>
          <p:cNvSpPr txBox="1"/>
          <p:nvPr/>
        </p:nvSpPr>
        <p:spPr>
          <a:xfrm>
            <a:off x="5760000" y="1404000"/>
            <a:ext cx="966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856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E8494EC1-01E9-415F-91B7-BD9C0253C653}"/>
              </a:ext>
            </a:extLst>
          </p:cNvPr>
          <p:cNvGrpSpPr/>
          <p:nvPr/>
        </p:nvGrpSpPr>
        <p:grpSpPr>
          <a:xfrm>
            <a:off x="5436000" y="1728000"/>
            <a:ext cx="1548000" cy="144000"/>
            <a:chOff x="1258295" y="314764"/>
            <a:chExt cx="1548000" cy="144000"/>
          </a:xfrm>
        </p:grpSpPr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BC77D9A9-7E90-4583-8488-2641746B4A09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752BB094-D312-4B58-9F7A-37F74D08A4CD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999560B4-9758-405B-B496-BAC0D3FA9F62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2F0A579-A951-4EF2-9DD1-6D095C04ADD5}"/>
              </a:ext>
            </a:extLst>
          </p:cNvPr>
          <p:cNvSpPr txBox="1"/>
          <p:nvPr/>
        </p:nvSpPr>
        <p:spPr>
          <a:xfrm>
            <a:off x="9720000" y="1404000"/>
            <a:ext cx="966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200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C552836F-0E8E-43F3-9B53-0C76506AAAD9}"/>
              </a:ext>
            </a:extLst>
          </p:cNvPr>
          <p:cNvGrpSpPr/>
          <p:nvPr/>
        </p:nvGrpSpPr>
        <p:grpSpPr>
          <a:xfrm>
            <a:off x="9396000" y="1728000"/>
            <a:ext cx="1548000" cy="144000"/>
            <a:chOff x="1258295" y="314764"/>
            <a:chExt cx="1548000" cy="144000"/>
          </a:xfrm>
        </p:grpSpPr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E90F7D6A-892E-41F1-A60B-762BB9432560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A1FA63B1-4AC4-4F5E-BD36-4FF9E1B959CE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860A6719-E8C9-4EFC-8286-835CA30E3702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8C88B01-9FEE-410C-A378-67D5F3A1F758}"/>
              </a:ext>
            </a:extLst>
          </p:cNvPr>
          <p:cNvSpPr txBox="1"/>
          <p:nvPr/>
        </p:nvSpPr>
        <p:spPr>
          <a:xfrm>
            <a:off x="180000" y="1080000"/>
            <a:ext cx="37080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FCE4EF8-686D-4838-86BD-DEF286E40D5E}"/>
              </a:ext>
            </a:extLst>
          </p:cNvPr>
          <p:cNvSpPr txBox="1"/>
          <p:nvPr/>
        </p:nvSpPr>
        <p:spPr>
          <a:xfrm>
            <a:off x="4140000" y="1080000"/>
            <a:ext cx="37080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D976292-00E0-4F15-9F4F-12B48E822AA4}"/>
              </a:ext>
            </a:extLst>
          </p:cNvPr>
          <p:cNvSpPr txBox="1"/>
          <p:nvPr/>
        </p:nvSpPr>
        <p:spPr>
          <a:xfrm>
            <a:off x="8100000" y="1080000"/>
            <a:ext cx="37080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91A6565-E0D8-4794-A9E1-BF7DEBDB7CBF}"/>
              </a:ext>
            </a:extLst>
          </p:cNvPr>
          <p:cNvSpPr/>
          <p:nvPr/>
        </p:nvSpPr>
        <p:spPr>
          <a:xfrm>
            <a:off x="-9572" y="-1"/>
            <a:ext cx="1220157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</a:t>
            </a:r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A6957D9-10C3-4FEA-A6C9-B32143137181}"/>
              </a:ext>
            </a:extLst>
          </p:cNvPr>
          <p:cNvSpPr txBox="1"/>
          <p:nvPr/>
        </p:nvSpPr>
        <p:spPr>
          <a:xfrm>
            <a:off x="1184817" y="4781001"/>
            <a:ext cx="6533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n=27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4F27143-5A8D-4E54-96BE-A1A6706268B3}"/>
              </a:ext>
            </a:extLst>
          </p:cNvPr>
          <p:cNvSpPr txBox="1"/>
          <p:nvPr/>
        </p:nvSpPr>
        <p:spPr>
          <a:xfrm>
            <a:off x="5066577" y="4781001"/>
            <a:ext cx="6533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n=27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8A995DF-893E-411C-9836-63458B140235}"/>
              </a:ext>
            </a:extLst>
          </p:cNvPr>
          <p:cNvSpPr txBox="1"/>
          <p:nvPr/>
        </p:nvSpPr>
        <p:spPr>
          <a:xfrm>
            <a:off x="9055341" y="4778012"/>
            <a:ext cx="6285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n=27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E9EA48B-3847-4E2D-9449-4CC0A6C30127}"/>
              </a:ext>
            </a:extLst>
          </p:cNvPr>
          <p:cNvSpPr txBox="1"/>
          <p:nvPr/>
        </p:nvSpPr>
        <p:spPr>
          <a:xfrm>
            <a:off x="6610781" y="4781001"/>
            <a:ext cx="628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n=2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D852A17-99F2-48DD-8588-E531605889E0}"/>
              </a:ext>
            </a:extLst>
          </p:cNvPr>
          <p:cNvSpPr txBox="1"/>
          <p:nvPr/>
        </p:nvSpPr>
        <p:spPr>
          <a:xfrm>
            <a:off x="2666181" y="4781002"/>
            <a:ext cx="653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n=2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0B5CEBE-10AD-4531-B8E5-62B6DA797059}"/>
              </a:ext>
            </a:extLst>
          </p:cNvPr>
          <p:cNvSpPr txBox="1"/>
          <p:nvPr/>
        </p:nvSpPr>
        <p:spPr>
          <a:xfrm>
            <a:off x="10574708" y="4778012"/>
            <a:ext cx="628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n=2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86728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F6705248-B3C1-C64E-B3BD-DE6F1C0FCB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845" y="1806081"/>
            <a:ext cx="3618000" cy="2676554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2B8AC02B-EB1E-8F50-62E1-8470ECBADD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53404" y="1810594"/>
            <a:ext cx="3618000" cy="2676554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E1CE2CB2-6AE8-F93E-716C-70A73F57E2A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6000" y="1806081"/>
            <a:ext cx="4034697" cy="26784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9C13CFFF-83AA-7037-BDFC-61DEFFCF4D5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14156"/>
          <a:stretch/>
        </p:blipFill>
        <p:spPr>
          <a:xfrm>
            <a:off x="9052392" y="1808971"/>
            <a:ext cx="3105822" cy="2676554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52B4857-F691-4CB0-89E9-18D60CA78F33}"/>
              </a:ext>
            </a:extLst>
          </p:cNvPr>
          <p:cNvSpPr txBox="1"/>
          <p:nvPr/>
        </p:nvSpPr>
        <p:spPr>
          <a:xfrm>
            <a:off x="1340178" y="1258482"/>
            <a:ext cx="966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44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831B04F5-B926-4BE1-945C-807C351ACA9A}"/>
              </a:ext>
            </a:extLst>
          </p:cNvPr>
          <p:cNvGrpSpPr/>
          <p:nvPr/>
        </p:nvGrpSpPr>
        <p:grpSpPr>
          <a:xfrm>
            <a:off x="1175446" y="1600804"/>
            <a:ext cx="1296000" cy="144000"/>
            <a:chOff x="1226304" y="1831893"/>
            <a:chExt cx="1296000" cy="144000"/>
          </a:xfrm>
        </p:grpSpPr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27C90679-FBEA-4BC8-9AB2-8CC6F9020C16}"/>
                </a:ext>
              </a:extLst>
            </p:cNvPr>
            <p:cNvCxnSpPr/>
            <p:nvPr/>
          </p:nvCxnSpPr>
          <p:spPr>
            <a:xfrm>
              <a:off x="1226304" y="1831893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E166DF4B-A54B-4E2F-844F-4B078F3A1148}"/>
                </a:ext>
              </a:extLst>
            </p:cNvPr>
            <p:cNvCxnSpPr/>
            <p:nvPr/>
          </p:nvCxnSpPr>
          <p:spPr>
            <a:xfrm>
              <a:off x="2522304" y="1831893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FB4CE9E6-8872-456E-AC7D-F2150FDDDC19}"/>
                </a:ext>
              </a:extLst>
            </p:cNvPr>
            <p:cNvCxnSpPr/>
            <p:nvPr/>
          </p:nvCxnSpPr>
          <p:spPr>
            <a:xfrm>
              <a:off x="1226304" y="1831893"/>
              <a:ext cx="129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2F0A579-A951-4EF2-9DD1-6D095C04ADD5}"/>
              </a:ext>
            </a:extLst>
          </p:cNvPr>
          <p:cNvSpPr txBox="1"/>
          <p:nvPr/>
        </p:nvSpPr>
        <p:spPr>
          <a:xfrm>
            <a:off x="4298236" y="1260306"/>
            <a:ext cx="966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451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C14319D-6786-4BF9-8C04-5A5DA30938B3}"/>
              </a:ext>
            </a:extLst>
          </p:cNvPr>
          <p:cNvSpPr txBox="1"/>
          <p:nvPr/>
        </p:nvSpPr>
        <p:spPr>
          <a:xfrm>
            <a:off x="10390034" y="1260305"/>
            <a:ext cx="966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6656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0357FCC-941F-488F-9C1E-61D82A181DCF}"/>
              </a:ext>
            </a:extLst>
          </p:cNvPr>
          <p:cNvSpPr txBox="1"/>
          <p:nvPr/>
        </p:nvSpPr>
        <p:spPr>
          <a:xfrm>
            <a:off x="7146811" y="1258482"/>
            <a:ext cx="966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9519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D07719ED-23DF-4019-8766-0DAFAAFA57E9}"/>
              </a:ext>
            </a:extLst>
          </p:cNvPr>
          <p:cNvGrpSpPr>
            <a:grpSpLocks noChangeAspect="1"/>
          </p:cNvGrpSpPr>
          <p:nvPr/>
        </p:nvGrpSpPr>
        <p:grpSpPr>
          <a:xfrm>
            <a:off x="8090482" y="1999511"/>
            <a:ext cx="331658" cy="132851"/>
            <a:chOff x="4125724" y="5127480"/>
            <a:chExt cx="2630937" cy="1053863"/>
          </a:xfrm>
          <a:noFill/>
        </p:grpSpPr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B0EBA25B-9991-4345-8FFF-1973B9D149DC}"/>
                </a:ext>
              </a:extLst>
            </p:cNvPr>
            <p:cNvSpPr/>
            <p:nvPr/>
          </p:nvSpPr>
          <p:spPr>
            <a:xfrm>
              <a:off x="4125724" y="5127480"/>
              <a:ext cx="2590384" cy="1053863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56" name="グループ化 55">
              <a:extLst>
                <a:ext uri="{FF2B5EF4-FFF2-40B4-BE49-F238E27FC236}">
                  <a16:creationId xmlns:a16="http://schemas.microsoft.com/office/drawing/2014/main" id="{6BAEC375-D1C7-4515-B16E-1CBDC5F8D190}"/>
                </a:ext>
              </a:extLst>
            </p:cNvPr>
            <p:cNvGrpSpPr/>
            <p:nvPr/>
          </p:nvGrpSpPr>
          <p:grpSpPr>
            <a:xfrm>
              <a:off x="4154334" y="5204576"/>
              <a:ext cx="2602327" cy="976767"/>
              <a:chOff x="-1447800" y="3884354"/>
              <a:chExt cx="669824" cy="251413"/>
            </a:xfrm>
            <a:grpFill/>
          </p:grpSpPr>
          <p:sp>
            <p:nvSpPr>
              <p:cNvPr id="57" name="フリーフォーム: 図形 56">
                <a:extLst>
                  <a:ext uri="{FF2B5EF4-FFF2-40B4-BE49-F238E27FC236}">
                    <a16:creationId xmlns:a16="http://schemas.microsoft.com/office/drawing/2014/main" id="{35CCD35E-2526-411D-9C0B-1124AA65408B}"/>
                  </a:ext>
                </a:extLst>
              </p:cNvPr>
              <p:cNvSpPr/>
              <p:nvPr/>
            </p:nvSpPr>
            <p:spPr>
              <a:xfrm>
                <a:off x="-1447800" y="3884354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grpFill/>
              <a:ln w="127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8" name="フリーフォーム: 図形 57">
                <a:extLst>
                  <a:ext uri="{FF2B5EF4-FFF2-40B4-BE49-F238E27FC236}">
                    <a16:creationId xmlns:a16="http://schemas.microsoft.com/office/drawing/2014/main" id="{7FD85933-22EA-4DEA-B556-A8147B84006B}"/>
                  </a:ext>
                </a:extLst>
              </p:cNvPr>
              <p:cNvSpPr/>
              <p:nvPr/>
            </p:nvSpPr>
            <p:spPr>
              <a:xfrm>
                <a:off x="-1444726" y="3945972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</p:grp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6D5DD188-89A9-4580-A88C-5839A27E77DA}"/>
              </a:ext>
            </a:extLst>
          </p:cNvPr>
          <p:cNvSpPr txBox="1"/>
          <p:nvPr/>
        </p:nvSpPr>
        <p:spPr>
          <a:xfrm>
            <a:off x="8043595" y="1747050"/>
            <a:ext cx="198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/>
              <a:t>・</a:t>
            </a:r>
            <a:endParaRPr kumimoji="1" lang="ja-JP" altLang="en-US" dirty="0"/>
          </a:p>
        </p:txBody>
      </p: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EF4FCDA0-ED4D-4154-8298-F2D3CBC230E9}"/>
              </a:ext>
            </a:extLst>
          </p:cNvPr>
          <p:cNvGrpSpPr/>
          <p:nvPr/>
        </p:nvGrpSpPr>
        <p:grpSpPr>
          <a:xfrm>
            <a:off x="7004910" y="1632566"/>
            <a:ext cx="1296000" cy="144000"/>
            <a:chOff x="1226304" y="1831893"/>
            <a:chExt cx="1296000" cy="144000"/>
          </a:xfrm>
        </p:grpSpPr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37CEFD4A-FAD5-449D-A9AC-C2F6FBAED6B2}"/>
                </a:ext>
              </a:extLst>
            </p:cNvPr>
            <p:cNvCxnSpPr/>
            <p:nvPr/>
          </p:nvCxnSpPr>
          <p:spPr>
            <a:xfrm>
              <a:off x="1226304" y="1831893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531CD6E3-5DBA-471B-8D00-5B044D367EE7}"/>
                </a:ext>
              </a:extLst>
            </p:cNvPr>
            <p:cNvCxnSpPr/>
            <p:nvPr/>
          </p:nvCxnSpPr>
          <p:spPr>
            <a:xfrm>
              <a:off x="2522304" y="1831893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50070C94-2387-4752-A3E2-93CCC10F2908}"/>
                </a:ext>
              </a:extLst>
            </p:cNvPr>
            <p:cNvCxnSpPr/>
            <p:nvPr/>
          </p:nvCxnSpPr>
          <p:spPr>
            <a:xfrm>
              <a:off x="1226304" y="1831893"/>
              <a:ext cx="129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030D4C40-1E27-46D0-8AB3-5541984AE843}"/>
              </a:ext>
            </a:extLst>
          </p:cNvPr>
          <p:cNvGrpSpPr/>
          <p:nvPr/>
        </p:nvGrpSpPr>
        <p:grpSpPr>
          <a:xfrm>
            <a:off x="4133505" y="1627988"/>
            <a:ext cx="1296000" cy="144000"/>
            <a:chOff x="1226304" y="1831893"/>
            <a:chExt cx="1296000" cy="144000"/>
          </a:xfrm>
        </p:grpSpPr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5CE5F763-6AF0-4910-83F2-CBFF2F837356}"/>
                </a:ext>
              </a:extLst>
            </p:cNvPr>
            <p:cNvCxnSpPr/>
            <p:nvPr/>
          </p:nvCxnSpPr>
          <p:spPr>
            <a:xfrm>
              <a:off x="1226304" y="1831893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A0206111-1CC8-44F4-9078-4F6F4F6C9070}"/>
                </a:ext>
              </a:extLst>
            </p:cNvPr>
            <p:cNvCxnSpPr/>
            <p:nvPr/>
          </p:nvCxnSpPr>
          <p:spPr>
            <a:xfrm>
              <a:off x="2522304" y="1831893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2F2BF1C4-9CA9-4188-850E-AFFB42038FBD}"/>
                </a:ext>
              </a:extLst>
            </p:cNvPr>
            <p:cNvCxnSpPr/>
            <p:nvPr/>
          </p:nvCxnSpPr>
          <p:spPr>
            <a:xfrm>
              <a:off x="1226304" y="1831893"/>
              <a:ext cx="129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5FB81C3D-361C-4247-A99A-EC4544B74773}"/>
              </a:ext>
            </a:extLst>
          </p:cNvPr>
          <p:cNvGrpSpPr/>
          <p:nvPr/>
        </p:nvGrpSpPr>
        <p:grpSpPr>
          <a:xfrm>
            <a:off x="10225302" y="1626191"/>
            <a:ext cx="1296000" cy="144000"/>
            <a:chOff x="1226304" y="1831893"/>
            <a:chExt cx="1296000" cy="144000"/>
          </a:xfrm>
        </p:grpSpPr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6BCC304A-6F64-430F-8838-3657725857BD}"/>
                </a:ext>
              </a:extLst>
            </p:cNvPr>
            <p:cNvCxnSpPr/>
            <p:nvPr/>
          </p:nvCxnSpPr>
          <p:spPr>
            <a:xfrm>
              <a:off x="1226304" y="1831893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5FD5CA93-2123-4D76-A58B-4F005A11D043}"/>
                </a:ext>
              </a:extLst>
            </p:cNvPr>
            <p:cNvCxnSpPr/>
            <p:nvPr/>
          </p:nvCxnSpPr>
          <p:spPr>
            <a:xfrm>
              <a:off x="2522304" y="1831893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B662B93C-A4E6-4E82-86FB-42B168B24C63}"/>
                </a:ext>
              </a:extLst>
            </p:cNvPr>
            <p:cNvCxnSpPr/>
            <p:nvPr/>
          </p:nvCxnSpPr>
          <p:spPr>
            <a:xfrm>
              <a:off x="1226304" y="1831893"/>
              <a:ext cx="129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44D23BAE-50AE-4A20-9A6A-8A00134A88A9}"/>
              </a:ext>
            </a:extLst>
          </p:cNvPr>
          <p:cNvSpPr txBox="1"/>
          <p:nvPr/>
        </p:nvSpPr>
        <p:spPr>
          <a:xfrm>
            <a:off x="0" y="889150"/>
            <a:ext cx="38112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02B83B23-1D40-44D4-B0BB-CB34BFDF6E7F}"/>
              </a:ext>
            </a:extLst>
          </p:cNvPr>
          <p:cNvSpPr txBox="1"/>
          <p:nvPr/>
        </p:nvSpPr>
        <p:spPr>
          <a:xfrm>
            <a:off x="2958058" y="889150"/>
            <a:ext cx="38112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60E44553-40AE-486F-AB2B-9660C599187D}"/>
              </a:ext>
            </a:extLst>
          </p:cNvPr>
          <p:cNvSpPr txBox="1"/>
          <p:nvPr/>
        </p:nvSpPr>
        <p:spPr>
          <a:xfrm>
            <a:off x="6040084" y="889150"/>
            <a:ext cx="38112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EE374E00-690A-444B-87DB-B242F7AAD68C}"/>
              </a:ext>
            </a:extLst>
          </p:cNvPr>
          <p:cNvSpPr txBox="1"/>
          <p:nvPr/>
        </p:nvSpPr>
        <p:spPr>
          <a:xfrm>
            <a:off x="9044121" y="889150"/>
            <a:ext cx="38112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BA15DDD0-96E6-49FE-928A-2199A1D9DC2F}"/>
              </a:ext>
            </a:extLst>
          </p:cNvPr>
          <p:cNvSpPr/>
          <p:nvPr/>
        </p:nvSpPr>
        <p:spPr>
          <a:xfrm>
            <a:off x="6269994" y="1909848"/>
            <a:ext cx="157625" cy="1328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62" name="グループ化 61">
            <a:extLst>
              <a:ext uri="{FF2B5EF4-FFF2-40B4-BE49-F238E27FC236}">
                <a16:creationId xmlns:a16="http://schemas.microsoft.com/office/drawing/2014/main" id="{E805C9E1-9771-4CB9-8AFD-D7A7CB407961}"/>
              </a:ext>
            </a:extLst>
          </p:cNvPr>
          <p:cNvGrpSpPr>
            <a:grpSpLocks noChangeAspect="1"/>
          </p:cNvGrpSpPr>
          <p:nvPr/>
        </p:nvGrpSpPr>
        <p:grpSpPr>
          <a:xfrm>
            <a:off x="6211289" y="1991517"/>
            <a:ext cx="331658" cy="132851"/>
            <a:chOff x="4125724" y="5127480"/>
            <a:chExt cx="2630937" cy="1053863"/>
          </a:xfrm>
          <a:noFill/>
        </p:grpSpPr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B73CFD28-774E-4EA6-A573-C6EB911897DF}"/>
                </a:ext>
              </a:extLst>
            </p:cNvPr>
            <p:cNvSpPr/>
            <p:nvPr/>
          </p:nvSpPr>
          <p:spPr>
            <a:xfrm>
              <a:off x="4125724" y="5127480"/>
              <a:ext cx="2590384" cy="1053863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64" name="グループ化 63">
              <a:extLst>
                <a:ext uri="{FF2B5EF4-FFF2-40B4-BE49-F238E27FC236}">
                  <a16:creationId xmlns:a16="http://schemas.microsoft.com/office/drawing/2014/main" id="{9D9754CF-FBBF-480A-B29C-2D0A35EC2FA5}"/>
                </a:ext>
              </a:extLst>
            </p:cNvPr>
            <p:cNvGrpSpPr/>
            <p:nvPr/>
          </p:nvGrpSpPr>
          <p:grpSpPr>
            <a:xfrm>
              <a:off x="4154334" y="5204576"/>
              <a:ext cx="2602327" cy="976767"/>
              <a:chOff x="-1447800" y="3884354"/>
              <a:chExt cx="669824" cy="251413"/>
            </a:xfrm>
            <a:grpFill/>
          </p:grpSpPr>
          <p:sp>
            <p:nvSpPr>
              <p:cNvPr id="65" name="フリーフォーム: 図形 64">
                <a:extLst>
                  <a:ext uri="{FF2B5EF4-FFF2-40B4-BE49-F238E27FC236}">
                    <a16:creationId xmlns:a16="http://schemas.microsoft.com/office/drawing/2014/main" id="{7DE70494-D9B2-4F55-9EAF-D9F1D9C4FF7E}"/>
                  </a:ext>
                </a:extLst>
              </p:cNvPr>
              <p:cNvSpPr/>
              <p:nvPr/>
            </p:nvSpPr>
            <p:spPr>
              <a:xfrm>
                <a:off x="-1447800" y="3884354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grpFill/>
              <a:ln w="127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75" name="フリーフォーム: 図形 74">
                <a:extLst>
                  <a:ext uri="{FF2B5EF4-FFF2-40B4-BE49-F238E27FC236}">
                    <a16:creationId xmlns:a16="http://schemas.microsoft.com/office/drawing/2014/main" id="{73358D02-ED70-4549-93BD-D6554C7B7354}"/>
                  </a:ext>
                </a:extLst>
              </p:cNvPr>
              <p:cNvSpPr/>
              <p:nvPr/>
            </p:nvSpPr>
            <p:spPr>
              <a:xfrm>
                <a:off x="-1444726" y="3945972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</p:grpSp>
      <p:sp>
        <p:nvSpPr>
          <p:cNvPr id="76" name="正方形/長方形 75">
            <a:extLst>
              <a:ext uri="{FF2B5EF4-FFF2-40B4-BE49-F238E27FC236}">
                <a16:creationId xmlns:a16="http://schemas.microsoft.com/office/drawing/2014/main" id="{7A0DC778-3C8A-41B8-AAAF-91E35D08676E}"/>
              </a:ext>
            </a:extLst>
          </p:cNvPr>
          <p:cNvSpPr/>
          <p:nvPr/>
        </p:nvSpPr>
        <p:spPr>
          <a:xfrm>
            <a:off x="-9572" y="-2"/>
            <a:ext cx="1215834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9A4568E1-14A1-4FC6-9E8E-DEFB5090502C}"/>
              </a:ext>
            </a:extLst>
          </p:cNvPr>
          <p:cNvSpPr txBox="1"/>
          <p:nvPr/>
        </p:nvSpPr>
        <p:spPr>
          <a:xfrm>
            <a:off x="898063" y="4299672"/>
            <a:ext cx="653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7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621DF249-5E97-4B88-98B3-17104A44EF55}"/>
              </a:ext>
            </a:extLst>
          </p:cNvPr>
          <p:cNvSpPr txBox="1"/>
          <p:nvPr/>
        </p:nvSpPr>
        <p:spPr>
          <a:xfrm>
            <a:off x="3794448" y="4299671"/>
            <a:ext cx="653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7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BD10210C-0502-4C58-A1D1-3D85ED44785E}"/>
              </a:ext>
            </a:extLst>
          </p:cNvPr>
          <p:cNvSpPr txBox="1"/>
          <p:nvPr/>
        </p:nvSpPr>
        <p:spPr>
          <a:xfrm>
            <a:off x="6785400" y="4293749"/>
            <a:ext cx="628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7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003D6D61-4780-4F1F-B9A4-02AA8916F6AD}"/>
              </a:ext>
            </a:extLst>
          </p:cNvPr>
          <p:cNvSpPr txBox="1"/>
          <p:nvPr/>
        </p:nvSpPr>
        <p:spPr>
          <a:xfrm>
            <a:off x="5116106" y="4299670"/>
            <a:ext cx="628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0C6A8FF9-EF7F-4C61-BED7-3A897729B32D}"/>
              </a:ext>
            </a:extLst>
          </p:cNvPr>
          <p:cNvSpPr txBox="1"/>
          <p:nvPr/>
        </p:nvSpPr>
        <p:spPr>
          <a:xfrm>
            <a:off x="2161984" y="4299672"/>
            <a:ext cx="6533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806DBE48-C23B-4D7C-9FAB-1559D4E0656F}"/>
              </a:ext>
            </a:extLst>
          </p:cNvPr>
          <p:cNvSpPr txBox="1"/>
          <p:nvPr/>
        </p:nvSpPr>
        <p:spPr>
          <a:xfrm>
            <a:off x="8016289" y="4293749"/>
            <a:ext cx="628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D6CF82FF-9E50-4A77-BD29-2B331D708BF8}"/>
              </a:ext>
            </a:extLst>
          </p:cNvPr>
          <p:cNvSpPr txBox="1"/>
          <p:nvPr/>
        </p:nvSpPr>
        <p:spPr>
          <a:xfrm>
            <a:off x="9862372" y="4293749"/>
            <a:ext cx="628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7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56223C44-CC08-4CC5-8F59-5206687A0DE1}"/>
              </a:ext>
            </a:extLst>
          </p:cNvPr>
          <p:cNvSpPr txBox="1"/>
          <p:nvPr/>
        </p:nvSpPr>
        <p:spPr>
          <a:xfrm>
            <a:off x="11207049" y="4293749"/>
            <a:ext cx="628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0E7548ED-F93D-4478-93DD-A2039CC0891C}"/>
              </a:ext>
            </a:extLst>
          </p:cNvPr>
          <p:cNvSpPr txBox="1"/>
          <p:nvPr/>
        </p:nvSpPr>
        <p:spPr>
          <a:xfrm>
            <a:off x="6152944" y="1792176"/>
            <a:ext cx="38112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900" b="1" dirty="0"/>
              <a:t>35</a:t>
            </a:r>
            <a:endParaRPr kumimoji="1" lang="ja-JP" altLang="en-US" sz="900" b="1" dirty="0"/>
          </a:p>
        </p:txBody>
      </p:sp>
    </p:spTree>
    <p:extLst>
      <p:ext uri="{BB962C8B-B14F-4D97-AF65-F5344CB8AC3E}">
        <p14:creationId xmlns:p14="http://schemas.microsoft.com/office/powerpoint/2010/main" val="37939706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DDCBD14A-4F8A-D904-79F8-A50971AFD2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01991" y="1974711"/>
            <a:ext cx="5714267" cy="3946719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46657904-F5F9-06D2-67C5-0A15FB0C6C3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2565" y="1930720"/>
            <a:ext cx="5717479" cy="3948937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076BCD5-32F1-4F7D-A8A4-74347EDC2A3C}"/>
              </a:ext>
            </a:extLst>
          </p:cNvPr>
          <p:cNvSpPr txBox="1"/>
          <p:nvPr/>
        </p:nvSpPr>
        <p:spPr>
          <a:xfrm>
            <a:off x="-2" y="-15680"/>
            <a:ext cx="121919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6E379C1-A1D5-485E-8F3C-6D304A87B08F}"/>
              </a:ext>
            </a:extLst>
          </p:cNvPr>
          <p:cNvSpPr txBox="1"/>
          <p:nvPr/>
        </p:nvSpPr>
        <p:spPr>
          <a:xfrm>
            <a:off x="373295" y="1208218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6DB3BF4-C16C-4359-9DD0-D49F8ECBE76E}"/>
              </a:ext>
            </a:extLst>
          </p:cNvPr>
          <p:cNvSpPr txBox="1"/>
          <p:nvPr/>
        </p:nvSpPr>
        <p:spPr>
          <a:xfrm>
            <a:off x="5320867" y="1208218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12AD350B-F6B9-4DC5-9A81-9ACEED821B7E}"/>
              </a:ext>
            </a:extLst>
          </p:cNvPr>
          <p:cNvSpPr txBox="1"/>
          <p:nvPr/>
        </p:nvSpPr>
        <p:spPr>
          <a:xfrm>
            <a:off x="2614821" y="1485213"/>
            <a:ext cx="966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1098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3A77F2D6-316B-4BD5-A466-BD5EC06AD25F}"/>
              </a:ext>
            </a:extLst>
          </p:cNvPr>
          <p:cNvGrpSpPr/>
          <p:nvPr/>
        </p:nvGrpSpPr>
        <p:grpSpPr>
          <a:xfrm>
            <a:off x="1996252" y="1948463"/>
            <a:ext cx="2088000" cy="144000"/>
            <a:chOff x="1258295" y="314764"/>
            <a:chExt cx="1548000" cy="144000"/>
          </a:xfrm>
        </p:grpSpPr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B892D0D0-B43D-4061-8726-2128047A5508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25F62FB4-ECC9-4AFA-A292-BAC361B49CAB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F86ABF77-B442-4962-B5FE-BFE7C4D4D630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1826E896-F6DD-4AB7-AD94-B9C8EC713090}"/>
              </a:ext>
            </a:extLst>
          </p:cNvPr>
          <p:cNvSpPr txBox="1"/>
          <p:nvPr/>
        </p:nvSpPr>
        <p:spPr>
          <a:xfrm>
            <a:off x="7823136" y="1485212"/>
            <a:ext cx="966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55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97272015-48C8-4EB6-A73A-96C7B74708BB}"/>
              </a:ext>
            </a:extLst>
          </p:cNvPr>
          <p:cNvGrpSpPr/>
          <p:nvPr/>
        </p:nvGrpSpPr>
        <p:grpSpPr>
          <a:xfrm>
            <a:off x="7262405" y="1948463"/>
            <a:ext cx="2088000" cy="144000"/>
            <a:chOff x="1258295" y="314764"/>
            <a:chExt cx="1548000" cy="144000"/>
          </a:xfrm>
        </p:grpSpPr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F26D4D23-172B-4305-A829-CB690AAD8FD4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C1C522E3-D15C-45BD-A738-65C580C78E6C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C6A70703-EC70-49B0-A6B8-FBD77FBC46B1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7D3E230-E0A2-4353-B554-19D6A02ADB19}"/>
              </a:ext>
            </a:extLst>
          </p:cNvPr>
          <p:cNvSpPr txBox="1"/>
          <p:nvPr/>
        </p:nvSpPr>
        <p:spPr>
          <a:xfrm>
            <a:off x="7956026" y="5599768"/>
            <a:ext cx="7007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394A3190-46AA-4C54-8023-FE485DBF80EA}"/>
              </a:ext>
            </a:extLst>
          </p:cNvPr>
          <p:cNvGrpSpPr/>
          <p:nvPr/>
        </p:nvGrpSpPr>
        <p:grpSpPr>
          <a:xfrm>
            <a:off x="3923614" y="6137604"/>
            <a:ext cx="1495952" cy="615555"/>
            <a:chOff x="10162648" y="5538200"/>
            <a:chExt cx="1495952" cy="615555"/>
          </a:xfrm>
        </p:grpSpPr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334EC4C5-2905-41F2-9DAC-3682AF2376DE}"/>
                </a:ext>
              </a:extLst>
            </p:cNvPr>
            <p:cNvSpPr txBox="1"/>
            <p:nvPr/>
          </p:nvSpPr>
          <p:spPr>
            <a:xfrm>
              <a:off x="10162648" y="5610393"/>
              <a:ext cx="360000" cy="108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61AA8074-6624-43FF-B31F-AD96C2D8D16D}"/>
                </a:ext>
              </a:extLst>
            </p:cNvPr>
            <p:cNvSpPr txBox="1"/>
            <p:nvPr/>
          </p:nvSpPr>
          <p:spPr>
            <a:xfrm>
              <a:off x="10646218" y="5845978"/>
              <a:ext cx="10123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Reference 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987BC54F-E81B-42ED-98F3-F527C5117EF3}"/>
                </a:ext>
              </a:extLst>
            </p:cNvPr>
            <p:cNvSpPr txBox="1"/>
            <p:nvPr/>
          </p:nvSpPr>
          <p:spPr>
            <a:xfrm>
              <a:off x="10162648" y="5945866"/>
              <a:ext cx="360000" cy="10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549E5B3F-A568-4124-A9A5-3CE7F0AF4FAD}"/>
                </a:ext>
              </a:extLst>
            </p:cNvPr>
            <p:cNvSpPr txBox="1"/>
            <p:nvPr/>
          </p:nvSpPr>
          <p:spPr>
            <a:xfrm>
              <a:off x="10657385" y="5538200"/>
              <a:ext cx="5930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NAC 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8E9FDF2-4E6C-41D4-B758-869A4E4CF2DA}"/>
              </a:ext>
            </a:extLst>
          </p:cNvPr>
          <p:cNvSpPr txBox="1"/>
          <p:nvPr/>
        </p:nvSpPr>
        <p:spPr>
          <a:xfrm>
            <a:off x="1660599" y="5613653"/>
            <a:ext cx="7869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n=5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029AEB8-C72E-4A75-AE12-07451B70C8A7}"/>
              </a:ext>
            </a:extLst>
          </p:cNvPr>
          <p:cNvSpPr txBox="1"/>
          <p:nvPr/>
        </p:nvSpPr>
        <p:spPr>
          <a:xfrm>
            <a:off x="3825579" y="5613653"/>
            <a:ext cx="875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n=18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BC63FFC-2B25-4530-800E-AB1746EEECED}"/>
              </a:ext>
            </a:extLst>
          </p:cNvPr>
          <p:cNvSpPr txBox="1"/>
          <p:nvPr/>
        </p:nvSpPr>
        <p:spPr>
          <a:xfrm>
            <a:off x="6868914" y="5613653"/>
            <a:ext cx="7869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n=10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C76C144-3BCA-41C7-B92F-4731A4400189}"/>
              </a:ext>
            </a:extLst>
          </p:cNvPr>
          <p:cNvSpPr txBox="1"/>
          <p:nvPr/>
        </p:nvSpPr>
        <p:spPr>
          <a:xfrm>
            <a:off x="9099903" y="5613653"/>
            <a:ext cx="875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n=13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21731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図 25">
            <a:extLst>
              <a:ext uri="{FF2B5EF4-FFF2-40B4-BE49-F238E27FC236}">
                <a16:creationId xmlns:a16="http://schemas.microsoft.com/office/drawing/2014/main" id="{98A39BB0-CB64-2253-B0BB-2685A136F333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8057901" y="4066997"/>
            <a:ext cx="3600000" cy="2485422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5943F81B-CB36-C3F8-7E55-F77AC4AF1E2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58462" y="4046444"/>
            <a:ext cx="3600000" cy="2486441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A1645F29-E476-1AA3-E08B-B842EA8B0E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4033491"/>
            <a:ext cx="3600000" cy="2486441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ADC22FCE-AA20-0A9E-45A6-06F18518BFA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15979" y="810942"/>
            <a:ext cx="3600000" cy="2486441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62177BBF-04BA-3908-5882-310504125C1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36572" y="783094"/>
            <a:ext cx="3600000" cy="2486441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30327E60-22ED-3892-C20F-DDFF2DDDCFC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655" y="808275"/>
            <a:ext cx="3600000" cy="2486441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B63B84A-7349-4C70-B7CF-D157B26F0EBA}"/>
              </a:ext>
            </a:extLst>
          </p:cNvPr>
          <p:cNvSpPr txBox="1"/>
          <p:nvPr/>
        </p:nvSpPr>
        <p:spPr>
          <a:xfrm>
            <a:off x="0" y="360000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4890BA3-FEA6-4034-90BA-590B2D254BBC}"/>
              </a:ext>
            </a:extLst>
          </p:cNvPr>
          <p:cNvSpPr txBox="1"/>
          <p:nvPr/>
        </p:nvSpPr>
        <p:spPr>
          <a:xfrm>
            <a:off x="3958462" y="339119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164B3DB-75CB-4D9F-BA0D-DB78F95DA21F}"/>
              </a:ext>
            </a:extLst>
          </p:cNvPr>
          <p:cNvSpPr txBox="1"/>
          <p:nvPr/>
        </p:nvSpPr>
        <p:spPr>
          <a:xfrm>
            <a:off x="7867339" y="353653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B505580D-C505-4A43-8C26-B8A996156800}"/>
              </a:ext>
            </a:extLst>
          </p:cNvPr>
          <p:cNvSpPr txBox="1"/>
          <p:nvPr/>
        </p:nvSpPr>
        <p:spPr>
          <a:xfrm>
            <a:off x="1372198" y="455986"/>
            <a:ext cx="7975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8510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FFDF15C5-F7D8-4987-B7B2-C6B637BFE4AC}"/>
              </a:ext>
            </a:extLst>
          </p:cNvPr>
          <p:cNvGrpSpPr/>
          <p:nvPr/>
        </p:nvGrpSpPr>
        <p:grpSpPr>
          <a:xfrm>
            <a:off x="1140978" y="715397"/>
            <a:ext cx="1260000" cy="144000"/>
            <a:chOff x="1258295" y="314764"/>
            <a:chExt cx="1548000" cy="144000"/>
          </a:xfrm>
        </p:grpSpPr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F1D8C9EC-34E0-4E16-9F94-5A27AA5D99A4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802DF368-8485-471D-B58B-9C24DAE40190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3B2E56E8-0424-4E64-858C-C196545DAA8C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3A7ED9C-FE3A-42C1-B805-4538905D4A83}"/>
              </a:ext>
            </a:extLst>
          </p:cNvPr>
          <p:cNvSpPr txBox="1"/>
          <p:nvPr/>
        </p:nvSpPr>
        <p:spPr>
          <a:xfrm>
            <a:off x="5401583" y="451723"/>
            <a:ext cx="795394" cy="262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7429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F93D57A6-A47A-428F-8414-0F8CB1E80287}"/>
              </a:ext>
            </a:extLst>
          </p:cNvPr>
          <p:cNvSpPr txBox="1"/>
          <p:nvPr/>
        </p:nvSpPr>
        <p:spPr>
          <a:xfrm>
            <a:off x="9301261" y="454751"/>
            <a:ext cx="7919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7776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E91FCB2E-E163-49C6-8D1D-B399C78C4995}"/>
              </a:ext>
            </a:extLst>
          </p:cNvPr>
          <p:cNvGrpSpPr/>
          <p:nvPr/>
        </p:nvGrpSpPr>
        <p:grpSpPr>
          <a:xfrm>
            <a:off x="9017383" y="719498"/>
            <a:ext cx="1260000" cy="144000"/>
            <a:chOff x="1258295" y="314764"/>
            <a:chExt cx="1548000" cy="144000"/>
          </a:xfrm>
        </p:grpSpPr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D5575461-07C6-4F82-966D-6AA23E8AAE66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3FF9FE2D-6C7B-4D9C-B7FA-92266BFABA8A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AC508B3B-7B88-434E-937C-11EDE52451A4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8F7CA05-9BDA-48EB-ACE0-7ABB36F4AD26}"/>
              </a:ext>
            </a:extLst>
          </p:cNvPr>
          <p:cNvSpPr txBox="1"/>
          <p:nvPr/>
        </p:nvSpPr>
        <p:spPr>
          <a:xfrm>
            <a:off x="-2808" y="3503190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F83FE6D-7E88-44AD-8785-3DC9066091C1}"/>
              </a:ext>
            </a:extLst>
          </p:cNvPr>
          <p:cNvSpPr txBox="1"/>
          <p:nvPr/>
        </p:nvSpPr>
        <p:spPr>
          <a:xfrm>
            <a:off x="3958462" y="3502979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7CFC7E2-4116-49FB-A2BF-866671300EF1}"/>
              </a:ext>
            </a:extLst>
          </p:cNvPr>
          <p:cNvSpPr txBox="1"/>
          <p:nvPr/>
        </p:nvSpPr>
        <p:spPr>
          <a:xfrm>
            <a:off x="7911070" y="3515883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817F5B4-49F9-4671-9A40-BAEE44693D17}"/>
              </a:ext>
            </a:extLst>
          </p:cNvPr>
          <p:cNvSpPr txBox="1"/>
          <p:nvPr/>
        </p:nvSpPr>
        <p:spPr>
          <a:xfrm>
            <a:off x="1388037" y="3645048"/>
            <a:ext cx="8064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512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3" name="グループ化 52">
            <a:extLst>
              <a:ext uri="{FF2B5EF4-FFF2-40B4-BE49-F238E27FC236}">
                <a16:creationId xmlns:a16="http://schemas.microsoft.com/office/drawing/2014/main" id="{8ED1E5C5-F7A5-4064-85C3-070C872293CB}"/>
              </a:ext>
            </a:extLst>
          </p:cNvPr>
          <p:cNvGrpSpPr/>
          <p:nvPr/>
        </p:nvGrpSpPr>
        <p:grpSpPr>
          <a:xfrm>
            <a:off x="1140978" y="3879331"/>
            <a:ext cx="1260000" cy="144000"/>
            <a:chOff x="1258295" y="314764"/>
            <a:chExt cx="1548000" cy="144000"/>
          </a:xfrm>
        </p:grpSpPr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DABF3E32-8A43-488B-AE9B-338B33969E8C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6530A27A-D802-4CED-8CD4-1C324AE8020F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79F2BF57-FAAC-443B-A481-7B7D9CDF9FD9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0549E164-8BD4-4413-B648-D8C1C9ABB313}"/>
              </a:ext>
            </a:extLst>
          </p:cNvPr>
          <p:cNvSpPr txBox="1"/>
          <p:nvPr/>
        </p:nvSpPr>
        <p:spPr>
          <a:xfrm>
            <a:off x="5373775" y="3645048"/>
            <a:ext cx="9224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9254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BDDCE567-D17C-461D-A965-70E3B5F063A4}"/>
              </a:ext>
            </a:extLst>
          </p:cNvPr>
          <p:cNvGrpSpPr/>
          <p:nvPr/>
        </p:nvGrpSpPr>
        <p:grpSpPr>
          <a:xfrm>
            <a:off x="5105371" y="3892666"/>
            <a:ext cx="1260000" cy="144000"/>
            <a:chOff x="1258295" y="314764"/>
            <a:chExt cx="1548000" cy="144000"/>
          </a:xfrm>
        </p:grpSpPr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0EA65124-8DA7-4D56-8151-9917739897A6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11BB4A48-6BAC-4C47-9E8B-AEFBCF95C587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786700F5-DD16-4E79-A590-8A2AC0EACFAB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3B764101-C54F-4A29-9BA7-139E2E9B2CC5}"/>
              </a:ext>
            </a:extLst>
          </p:cNvPr>
          <p:cNvSpPr txBox="1"/>
          <p:nvPr/>
        </p:nvSpPr>
        <p:spPr>
          <a:xfrm>
            <a:off x="9253540" y="3642883"/>
            <a:ext cx="875742" cy="265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7787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86C2CD62-B7E4-4EA2-B1C6-4348901CDEE7}"/>
              </a:ext>
            </a:extLst>
          </p:cNvPr>
          <p:cNvGrpSpPr/>
          <p:nvPr/>
        </p:nvGrpSpPr>
        <p:grpSpPr>
          <a:xfrm>
            <a:off x="9023936" y="3900787"/>
            <a:ext cx="1260000" cy="144000"/>
            <a:chOff x="1258295" y="314764"/>
            <a:chExt cx="1548000" cy="144000"/>
          </a:xfrm>
        </p:grpSpPr>
        <p:cxnSp>
          <p:nvCxnSpPr>
            <p:cNvPr id="64" name="直線コネクタ 63">
              <a:extLst>
                <a:ext uri="{FF2B5EF4-FFF2-40B4-BE49-F238E27FC236}">
                  <a16:creationId xmlns:a16="http://schemas.microsoft.com/office/drawing/2014/main" id="{C4AA855A-0D98-48D2-A1CE-2BBAE9787D8C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E7B304EE-476E-4219-9A79-E22C4D20F07B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BDE81625-340C-4FB6-9C55-FEB4734BB9DC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F4DD065F-4E76-42E0-BBA9-5A3BB7438ACF}"/>
              </a:ext>
            </a:extLst>
          </p:cNvPr>
          <p:cNvSpPr txBox="1"/>
          <p:nvPr/>
        </p:nvSpPr>
        <p:spPr>
          <a:xfrm>
            <a:off x="0" y="-15679"/>
            <a:ext cx="6184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4.</a:t>
            </a:r>
            <a:endParaRPr kumimoji="1" lang="en-US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99CB95E3-C20F-46DB-BD81-7B49981F3D3D}"/>
              </a:ext>
            </a:extLst>
          </p:cNvPr>
          <p:cNvSpPr txBox="1"/>
          <p:nvPr/>
        </p:nvSpPr>
        <p:spPr>
          <a:xfrm>
            <a:off x="8103391" y="4032960"/>
            <a:ext cx="381124" cy="2154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2" name="グループ化 71">
            <a:extLst>
              <a:ext uri="{FF2B5EF4-FFF2-40B4-BE49-F238E27FC236}">
                <a16:creationId xmlns:a16="http://schemas.microsoft.com/office/drawing/2014/main" id="{6D2B4CD2-106F-4F5F-896A-B629AB135B5E}"/>
              </a:ext>
            </a:extLst>
          </p:cNvPr>
          <p:cNvGrpSpPr>
            <a:grpSpLocks noChangeAspect="1"/>
          </p:cNvGrpSpPr>
          <p:nvPr/>
        </p:nvGrpSpPr>
        <p:grpSpPr>
          <a:xfrm>
            <a:off x="8135377" y="4207866"/>
            <a:ext cx="331658" cy="132851"/>
            <a:chOff x="4125724" y="5127480"/>
            <a:chExt cx="2630937" cy="1053863"/>
          </a:xfrm>
        </p:grpSpPr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5D4F51A8-78BF-4489-8483-D16F0FE0F6D3}"/>
                </a:ext>
              </a:extLst>
            </p:cNvPr>
            <p:cNvSpPr/>
            <p:nvPr/>
          </p:nvSpPr>
          <p:spPr>
            <a:xfrm>
              <a:off x="4125724" y="5127480"/>
              <a:ext cx="2590384" cy="10538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74" name="グループ化 73">
              <a:extLst>
                <a:ext uri="{FF2B5EF4-FFF2-40B4-BE49-F238E27FC236}">
                  <a16:creationId xmlns:a16="http://schemas.microsoft.com/office/drawing/2014/main" id="{5A092B6D-4A19-4A9F-B1F4-6F6F9A6A8B32}"/>
                </a:ext>
              </a:extLst>
            </p:cNvPr>
            <p:cNvGrpSpPr/>
            <p:nvPr/>
          </p:nvGrpSpPr>
          <p:grpSpPr>
            <a:xfrm>
              <a:off x="4154334" y="5204576"/>
              <a:ext cx="2602327" cy="976767"/>
              <a:chOff x="-1447800" y="3884354"/>
              <a:chExt cx="669824" cy="251413"/>
            </a:xfrm>
          </p:grpSpPr>
          <p:sp>
            <p:nvSpPr>
              <p:cNvPr id="75" name="フリーフォーム: 図形 74">
                <a:extLst>
                  <a:ext uri="{FF2B5EF4-FFF2-40B4-BE49-F238E27FC236}">
                    <a16:creationId xmlns:a16="http://schemas.microsoft.com/office/drawing/2014/main" id="{53B0E7AB-1036-4875-B5E4-6F8AE532D21A}"/>
                  </a:ext>
                </a:extLst>
              </p:cNvPr>
              <p:cNvSpPr/>
              <p:nvPr/>
            </p:nvSpPr>
            <p:spPr>
              <a:xfrm>
                <a:off x="-1447800" y="3884354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noFill/>
              <a:ln w="127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76" name="フリーフォーム: 図形 75">
                <a:extLst>
                  <a:ext uri="{FF2B5EF4-FFF2-40B4-BE49-F238E27FC236}">
                    <a16:creationId xmlns:a16="http://schemas.microsoft.com/office/drawing/2014/main" id="{586960BF-0D3B-4FDC-BE7F-DCC1E5D6FF9B}"/>
                  </a:ext>
                </a:extLst>
              </p:cNvPr>
              <p:cNvSpPr/>
              <p:nvPr/>
            </p:nvSpPr>
            <p:spPr>
              <a:xfrm>
                <a:off x="-1444726" y="3945972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</p:grp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8E01D31B-FD67-4257-9955-5C421BD1E894}"/>
              </a:ext>
            </a:extLst>
          </p:cNvPr>
          <p:cNvGrpSpPr>
            <a:grpSpLocks noChangeAspect="1"/>
          </p:cNvGrpSpPr>
          <p:nvPr/>
        </p:nvGrpSpPr>
        <p:grpSpPr>
          <a:xfrm>
            <a:off x="8869210" y="4206474"/>
            <a:ext cx="331658" cy="132851"/>
            <a:chOff x="4125724" y="5127480"/>
            <a:chExt cx="2630937" cy="1053863"/>
          </a:xfrm>
          <a:noFill/>
        </p:grpSpPr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3AC288AF-BB36-40CB-8799-70C185561D2A}"/>
                </a:ext>
              </a:extLst>
            </p:cNvPr>
            <p:cNvSpPr/>
            <p:nvPr/>
          </p:nvSpPr>
          <p:spPr>
            <a:xfrm>
              <a:off x="4125724" y="5127480"/>
              <a:ext cx="2590384" cy="1053863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79" name="グループ化 78">
              <a:extLst>
                <a:ext uri="{FF2B5EF4-FFF2-40B4-BE49-F238E27FC236}">
                  <a16:creationId xmlns:a16="http://schemas.microsoft.com/office/drawing/2014/main" id="{3413F974-839A-4F91-9EA9-A5DD4003D87A}"/>
                </a:ext>
              </a:extLst>
            </p:cNvPr>
            <p:cNvGrpSpPr/>
            <p:nvPr/>
          </p:nvGrpSpPr>
          <p:grpSpPr>
            <a:xfrm>
              <a:off x="4154334" y="5204576"/>
              <a:ext cx="2602327" cy="976767"/>
              <a:chOff x="-1447800" y="3884354"/>
              <a:chExt cx="669824" cy="251413"/>
            </a:xfrm>
            <a:grpFill/>
          </p:grpSpPr>
          <p:sp>
            <p:nvSpPr>
              <p:cNvPr id="80" name="フリーフォーム: 図形 79">
                <a:extLst>
                  <a:ext uri="{FF2B5EF4-FFF2-40B4-BE49-F238E27FC236}">
                    <a16:creationId xmlns:a16="http://schemas.microsoft.com/office/drawing/2014/main" id="{07E6D329-E358-40F5-B039-72DB20EBB99D}"/>
                  </a:ext>
                </a:extLst>
              </p:cNvPr>
              <p:cNvSpPr/>
              <p:nvPr/>
            </p:nvSpPr>
            <p:spPr>
              <a:xfrm>
                <a:off x="-1447800" y="3884354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grpFill/>
              <a:ln w="127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81" name="フリーフォーム: 図形 80">
                <a:extLst>
                  <a:ext uri="{FF2B5EF4-FFF2-40B4-BE49-F238E27FC236}">
                    <a16:creationId xmlns:a16="http://schemas.microsoft.com/office/drawing/2014/main" id="{2DEEFD0A-221F-45F2-88B0-88FF122BC748}"/>
                  </a:ext>
                </a:extLst>
              </p:cNvPr>
              <p:cNvSpPr/>
              <p:nvPr/>
            </p:nvSpPr>
            <p:spPr>
              <a:xfrm>
                <a:off x="-1444726" y="3945972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grp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</p:grp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87EB7194-3A9F-492D-9AA4-446B76356AE6}"/>
              </a:ext>
            </a:extLst>
          </p:cNvPr>
          <p:cNvSpPr txBox="1"/>
          <p:nvPr/>
        </p:nvSpPr>
        <p:spPr>
          <a:xfrm>
            <a:off x="8825481" y="4029367"/>
            <a:ext cx="198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/>
              <a:t>・</a:t>
            </a:r>
            <a:endParaRPr kumimoji="1" lang="ja-JP" altLang="en-US" dirty="0"/>
          </a:p>
        </p:txBody>
      </p: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36A4C605-C40E-4F2D-861C-1B1178834B9E}"/>
              </a:ext>
            </a:extLst>
          </p:cNvPr>
          <p:cNvGrpSpPr/>
          <p:nvPr/>
        </p:nvGrpSpPr>
        <p:grpSpPr>
          <a:xfrm>
            <a:off x="5126774" y="710966"/>
            <a:ext cx="1260000" cy="144000"/>
            <a:chOff x="1258295" y="314764"/>
            <a:chExt cx="1548000" cy="144000"/>
          </a:xfrm>
        </p:grpSpPr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BEDA085E-FC9D-4F64-A8E7-4CEC5542D2E3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D2A54E6A-5F8B-4AA9-9A10-E66F08B952F3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012A6136-A217-4089-BF62-72A045523E04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AF72710A-8558-458F-9290-B218AB178EA8}"/>
              </a:ext>
            </a:extLst>
          </p:cNvPr>
          <p:cNvSpPr/>
          <p:nvPr/>
        </p:nvSpPr>
        <p:spPr>
          <a:xfrm>
            <a:off x="938463" y="3152760"/>
            <a:ext cx="1756608" cy="2104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id="{CAAAAD46-F668-4F2A-BD57-9EC19CA9BA9C}"/>
              </a:ext>
            </a:extLst>
          </p:cNvPr>
          <p:cNvSpPr/>
          <p:nvPr/>
        </p:nvSpPr>
        <p:spPr>
          <a:xfrm>
            <a:off x="4902302" y="3152760"/>
            <a:ext cx="1756608" cy="2104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正方形/長方形 85">
            <a:extLst>
              <a:ext uri="{FF2B5EF4-FFF2-40B4-BE49-F238E27FC236}">
                <a16:creationId xmlns:a16="http://schemas.microsoft.com/office/drawing/2014/main" id="{A1B7EF4B-8946-41DA-A7ED-AFE3F6085610}"/>
              </a:ext>
            </a:extLst>
          </p:cNvPr>
          <p:cNvSpPr/>
          <p:nvPr/>
        </p:nvSpPr>
        <p:spPr>
          <a:xfrm>
            <a:off x="8788293" y="3124750"/>
            <a:ext cx="1756608" cy="2104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1C80D72E-6EC3-453D-A07F-2BCFA2620F52}"/>
              </a:ext>
            </a:extLst>
          </p:cNvPr>
          <p:cNvSpPr/>
          <p:nvPr/>
        </p:nvSpPr>
        <p:spPr>
          <a:xfrm>
            <a:off x="892674" y="6421287"/>
            <a:ext cx="1756608" cy="2104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BA6EC3F8-6789-4F6D-8DD7-168ACD9CA5B1}"/>
              </a:ext>
            </a:extLst>
          </p:cNvPr>
          <p:cNvSpPr/>
          <p:nvPr/>
        </p:nvSpPr>
        <p:spPr>
          <a:xfrm>
            <a:off x="4958268" y="6474199"/>
            <a:ext cx="1756608" cy="2104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正方形/長方形 88">
            <a:extLst>
              <a:ext uri="{FF2B5EF4-FFF2-40B4-BE49-F238E27FC236}">
                <a16:creationId xmlns:a16="http://schemas.microsoft.com/office/drawing/2014/main" id="{BF1E9415-C8A3-4366-95F8-6CEE805E5F0C}"/>
              </a:ext>
            </a:extLst>
          </p:cNvPr>
          <p:cNvSpPr/>
          <p:nvPr/>
        </p:nvSpPr>
        <p:spPr>
          <a:xfrm>
            <a:off x="8813107" y="6456664"/>
            <a:ext cx="1756608" cy="2104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596A75B5-E96B-4FEC-8F2A-9B5CCB01254A}"/>
              </a:ext>
            </a:extLst>
          </p:cNvPr>
          <p:cNvSpPr txBox="1"/>
          <p:nvPr/>
        </p:nvSpPr>
        <p:spPr>
          <a:xfrm>
            <a:off x="833268" y="3096000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6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2A9AB623-E000-43F5-AAD1-F339F3DB79AA}"/>
              </a:ext>
            </a:extLst>
          </p:cNvPr>
          <p:cNvSpPr txBox="1"/>
          <p:nvPr/>
        </p:nvSpPr>
        <p:spPr>
          <a:xfrm>
            <a:off x="2112788" y="3096000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EB594424-5106-4BFB-9779-A86A566A18C4}"/>
              </a:ext>
            </a:extLst>
          </p:cNvPr>
          <p:cNvSpPr txBox="1"/>
          <p:nvPr/>
        </p:nvSpPr>
        <p:spPr>
          <a:xfrm>
            <a:off x="867152" y="6301007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6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78852B56-C595-4E7E-96E2-29BC47267375}"/>
              </a:ext>
            </a:extLst>
          </p:cNvPr>
          <p:cNvSpPr txBox="1"/>
          <p:nvPr/>
        </p:nvSpPr>
        <p:spPr>
          <a:xfrm>
            <a:off x="2130757" y="6306199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675F7593-BBEA-4B8A-B228-CF9F228593C7}"/>
              </a:ext>
            </a:extLst>
          </p:cNvPr>
          <p:cNvSpPr txBox="1"/>
          <p:nvPr/>
        </p:nvSpPr>
        <p:spPr>
          <a:xfrm>
            <a:off x="4886199" y="3084231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6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710A1AE8-44A9-4C22-B508-A43E2370A944}"/>
              </a:ext>
            </a:extLst>
          </p:cNvPr>
          <p:cNvSpPr txBox="1"/>
          <p:nvPr/>
        </p:nvSpPr>
        <p:spPr>
          <a:xfrm>
            <a:off x="6147813" y="3082625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2B3E550B-E508-4C13-9EAF-B526F353FFB1}"/>
              </a:ext>
            </a:extLst>
          </p:cNvPr>
          <p:cNvSpPr txBox="1"/>
          <p:nvPr/>
        </p:nvSpPr>
        <p:spPr>
          <a:xfrm>
            <a:off x="4837279" y="6306198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6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ED4DEB93-3732-433D-8567-4FE30AC0F98F}"/>
              </a:ext>
            </a:extLst>
          </p:cNvPr>
          <p:cNvSpPr txBox="1"/>
          <p:nvPr/>
        </p:nvSpPr>
        <p:spPr>
          <a:xfrm>
            <a:off x="6082531" y="6296431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CD2F0198-5F30-4B11-90E2-2F820227A2D9}"/>
              </a:ext>
            </a:extLst>
          </p:cNvPr>
          <p:cNvSpPr txBox="1"/>
          <p:nvPr/>
        </p:nvSpPr>
        <p:spPr>
          <a:xfrm>
            <a:off x="8731192" y="3096000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6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91898302-ABE9-43C9-BF13-E9BCD79C8113}"/>
              </a:ext>
            </a:extLst>
          </p:cNvPr>
          <p:cNvSpPr txBox="1"/>
          <p:nvPr/>
        </p:nvSpPr>
        <p:spPr>
          <a:xfrm>
            <a:off x="10025623" y="3096000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24434C2E-919A-4A53-B7B0-3F88058BFC89}"/>
              </a:ext>
            </a:extLst>
          </p:cNvPr>
          <p:cNvSpPr txBox="1"/>
          <p:nvPr/>
        </p:nvSpPr>
        <p:spPr>
          <a:xfrm>
            <a:off x="8804837" y="6295547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6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2D78DC48-97AB-4944-83F2-5BBBA3E8234A}"/>
              </a:ext>
            </a:extLst>
          </p:cNvPr>
          <p:cNvSpPr txBox="1"/>
          <p:nvPr/>
        </p:nvSpPr>
        <p:spPr>
          <a:xfrm>
            <a:off x="10120673" y="6308272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09C86AD8-096C-453A-B86F-D18D6068619C}"/>
              </a:ext>
            </a:extLst>
          </p:cNvPr>
          <p:cNvSpPr txBox="1"/>
          <p:nvPr/>
        </p:nvSpPr>
        <p:spPr>
          <a:xfrm>
            <a:off x="1047964" y="3271995"/>
            <a:ext cx="15352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RAS/RAF/MAP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kinas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D6233C21-115A-4B90-84FB-9F59249E5AC3}"/>
              </a:ext>
            </a:extLst>
          </p:cNvPr>
          <p:cNvSpPr txBox="1"/>
          <p:nvPr/>
        </p:nvSpPr>
        <p:spPr>
          <a:xfrm>
            <a:off x="1004654" y="6524809"/>
            <a:ext cx="15352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RAS/RAF/MAP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kinas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FDC34DC7-F6EA-4C46-AD3A-604DBC8D27C7}"/>
              </a:ext>
            </a:extLst>
          </p:cNvPr>
          <p:cNvSpPr txBox="1"/>
          <p:nvPr/>
        </p:nvSpPr>
        <p:spPr>
          <a:xfrm>
            <a:off x="5042189" y="6522419"/>
            <a:ext cx="15352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RAS/RAF/MAP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kinas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3472918D-E25D-4619-B3F2-05F0B38EF748}"/>
              </a:ext>
            </a:extLst>
          </p:cNvPr>
          <p:cNvSpPr txBox="1"/>
          <p:nvPr/>
        </p:nvSpPr>
        <p:spPr>
          <a:xfrm>
            <a:off x="5065109" y="3269662"/>
            <a:ext cx="15352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RAS/RAF/MAP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kinas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89996951-C5E0-4456-96EF-A7C855AB750A}"/>
              </a:ext>
            </a:extLst>
          </p:cNvPr>
          <p:cNvSpPr txBox="1"/>
          <p:nvPr/>
        </p:nvSpPr>
        <p:spPr>
          <a:xfrm>
            <a:off x="8954100" y="3278130"/>
            <a:ext cx="15352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RAS/RAF/MAP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kinas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42458CF8-802F-40A1-93AC-64ADE43459A1}"/>
              </a:ext>
            </a:extLst>
          </p:cNvPr>
          <p:cNvSpPr txBox="1"/>
          <p:nvPr/>
        </p:nvSpPr>
        <p:spPr>
          <a:xfrm>
            <a:off x="9028883" y="6522419"/>
            <a:ext cx="15352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RAS/RAF/MAP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kinas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27158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図 26">
            <a:extLst>
              <a:ext uri="{FF2B5EF4-FFF2-40B4-BE49-F238E27FC236}">
                <a16:creationId xmlns:a16="http://schemas.microsoft.com/office/drawing/2014/main" id="{8E28DA0F-8EF4-E49A-6E03-59467760BCEB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40907" y="781063"/>
            <a:ext cx="3855600" cy="2664000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564D7403-2368-79AA-2E4B-E7EC2F6474B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74682" y="4076524"/>
            <a:ext cx="3857079" cy="266400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A51F6BE4-8462-C449-D204-4B01377CFE3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27057" y="4069721"/>
            <a:ext cx="3857079" cy="266400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7A5ACBBE-3FBF-5619-E352-68DBE1F6A16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0168" y="4063648"/>
            <a:ext cx="3857079" cy="2664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BA245AC8-108B-6A38-9D66-F343DCBD976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69313" y="769706"/>
            <a:ext cx="3857079" cy="266400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08188731-CFFE-6FF2-CB9B-615D0DFD80F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27057" y="784396"/>
            <a:ext cx="3855600" cy="2662978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B63B84A-7349-4C70-B7CF-D157B26F0EBA}"/>
              </a:ext>
            </a:extLst>
          </p:cNvPr>
          <p:cNvSpPr txBox="1"/>
          <p:nvPr/>
        </p:nvSpPr>
        <p:spPr>
          <a:xfrm>
            <a:off x="0" y="360000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4890BA3-FEA6-4034-90BA-590B2D254BBC}"/>
              </a:ext>
            </a:extLst>
          </p:cNvPr>
          <p:cNvSpPr txBox="1"/>
          <p:nvPr/>
        </p:nvSpPr>
        <p:spPr>
          <a:xfrm>
            <a:off x="3704025" y="360000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164B3DB-75CB-4D9F-BA0D-DB78F95DA21F}"/>
              </a:ext>
            </a:extLst>
          </p:cNvPr>
          <p:cNvSpPr txBox="1"/>
          <p:nvPr/>
        </p:nvSpPr>
        <p:spPr>
          <a:xfrm>
            <a:off x="7485301" y="350791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B505580D-C505-4A43-8C26-B8A996156800}"/>
              </a:ext>
            </a:extLst>
          </p:cNvPr>
          <p:cNvSpPr txBox="1"/>
          <p:nvPr/>
        </p:nvSpPr>
        <p:spPr>
          <a:xfrm>
            <a:off x="1639529" y="455867"/>
            <a:ext cx="9665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0442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FFDF15C5-F7D8-4987-B7B2-C6B637BFE4AC}"/>
              </a:ext>
            </a:extLst>
          </p:cNvPr>
          <p:cNvGrpSpPr/>
          <p:nvPr/>
        </p:nvGrpSpPr>
        <p:grpSpPr>
          <a:xfrm>
            <a:off x="1417517" y="691268"/>
            <a:ext cx="1260000" cy="144000"/>
            <a:chOff x="1258295" y="314764"/>
            <a:chExt cx="1548000" cy="144000"/>
          </a:xfrm>
        </p:grpSpPr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F1D8C9EC-34E0-4E16-9F94-5A27AA5D99A4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802DF368-8485-471D-B58B-9C24DAE40190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3B2E56E8-0424-4E64-858C-C196545DAA8C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3A7ED9C-FE3A-42C1-B805-4538905D4A83}"/>
              </a:ext>
            </a:extLst>
          </p:cNvPr>
          <p:cNvSpPr txBox="1"/>
          <p:nvPr/>
        </p:nvSpPr>
        <p:spPr>
          <a:xfrm>
            <a:off x="5435154" y="455867"/>
            <a:ext cx="9665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1824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9528E933-7E83-4013-A963-8E68A515CB46}"/>
              </a:ext>
            </a:extLst>
          </p:cNvPr>
          <p:cNvGrpSpPr/>
          <p:nvPr/>
        </p:nvGrpSpPr>
        <p:grpSpPr>
          <a:xfrm>
            <a:off x="5198752" y="688725"/>
            <a:ext cx="1260000" cy="144000"/>
            <a:chOff x="1258295" y="314764"/>
            <a:chExt cx="1548000" cy="144000"/>
          </a:xfrm>
        </p:grpSpPr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B862731B-5D21-40D5-9CC4-BCDA54AF066D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575D7EFB-4C52-48A0-9FBB-8BECDBA6993B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143A9A21-3331-41DC-B192-A40DA48EE07A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F93D57A6-A47A-428F-8414-0F8CB1E80287}"/>
              </a:ext>
            </a:extLst>
          </p:cNvPr>
          <p:cNvSpPr txBox="1"/>
          <p:nvPr/>
        </p:nvSpPr>
        <p:spPr>
          <a:xfrm>
            <a:off x="9389157" y="461219"/>
            <a:ext cx="8173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1554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E91FCB2E-E163-49C6-8D1D-B399C78C4995}"/>
              </a:ext>
            </a:extLst>
          </p:cNvPr>
          <p:cNvGrpSpPr/>
          <p:nvPr/>
        </p:nvGrpSpPr>
        <p:grpSpPr>
          <a:xfrm>
            <a:off x="9167852" y="688725"/>
            <a:ext cx="1260000" cy="144000"/>
            <a:chOff x="1258295" y="314764"/>
            <a:chExt cx="1548000" cy="144000"/>
          </a:xfrm>
        </p:grpSpPr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D5575461-07C6-4F82-966D-6AA23E8AAE66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3FF9FE2D-6C7B-4D9C-B7FA-92266BFABA8A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AC508B3B-7B88-434E-937C-11EDE52451A4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8F7CA05-9BDA-48EB-ACE0-7ABB36F4AD26}"/>
              </a:ext>
            </a:extLst>
          </p:cNvPr>
          <p:cNvSpPr txBox="1"/>
          <p:nvPr/>
        </p:nvSpPr>
        <p:spPr>
          <a:xfrm>
            <a:off x="0" y="3708000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F83FE6D-7E88-44AD-8785-3DC9066091C1}"/>
              </a:ext>
            </a:extLst>
          </p:cNvPr>
          <p:cNvSpPr txBox="1"/>
          <p:nvPr/>
        </p:nvSpPr>
        <p:spPr>
          <a:xfrm>
            <a:off x="3705122" y="3708000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7CFC7E2-4116-49FB-A2BF-866671300EF1}"/>
              </a:ext>
            </a:extLst>
          </p:cNvPr>
          <p:cNvSpPr txBox="1"/>
          <p:nvPr/>
        </p:nvSpPr>
        <p:spPr>
          <a:xfrm>
            <a:off x="7544010" y="3708000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817F5B4-49F9-4671-9A40-BAEE44693D17}"/>
              </a:ext>
            </a:extLst>
          </p:cNvPr>
          <p:cNvSpPr txBox="1"/>
          <p:nvPr/>
        </p:nvSpPr>
        <p:spPr>
          <a:xfrm>
            <a:off x="1749448" y="3809296"/>
            <a:ext cx="9665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0455</a:t>
            </a:r>
          </a:p>
        </p:txBody>
      </p:sp>
      <p:grpSp>
        <p:nvGrpSpPr>
          <p:cNvPr id="53" name="グループ化 52">
            <a:extLst>
              <a:ext uri="{FF2B5EF4-FFF2-40B4-BE49-F238E27FC236}">
                <a16:creationId xmlns:a16="http://schemas.microsoft.com/office/drawing/2014/main" id="{8ED1E5C5-F7A5-4064-85C3-070C872293CB}"/>
              </a:ext>
            </a:extLst>
          </p:cNvPr>
          <p:cNvGrpSpPr/>
          <p:nvPr/>
        </p:nvGrpSpPr>
        <p:grpSpPr>
          <a:xfrm>
            <a:off x="1474055" y="4055063"/>
            <a:ext cx="1260000" cy="144000"/>
            <a:chOff x="1258295" y="314764"/>
            <a:chExt cx="1548000" cy="144000"/>
          </a:xfrm>
        </p:grpSpPr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DABF3E32-8A43-488B-AE9B-338B33969E8C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6530A27A-D802-4CED-8CD4-1C324AE8020F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79F2BF57-FAAC-443B-A481-7B7D9CDF9FD9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0549E164-8BD4-4413-B648-D8C1C9ABB313}"/>
              </a:ext>
            </a:extLst>
          </p:cNvPr>
          <p:cNvSpPr txBox="1"/>
          <p:nvPr/>
        </p:nvSpPr>
        <p:spPr>
          <a:xfrm>
            <a:off x="5449018" y="3809095"/>
            <a:ext cx="9665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0455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BDDCE567-D17C-461D-A965-70E3B5F063A4}"/>
              </a:ext>
            </a:extLst>
          </p:cNvPr>
          <p:cNvGrpSpPr/>
          <p:nvPr/>
        </p:nvGrpSpPr>
        <p:grpSpPr>
          <a:xfrm>
            <a:off x="5229771" y="4055063"/>
            <a:ext cx="1260000" cy="144000"/>
            <a:chOff x="1258295" y="314764"/>
            <a:chExt cx="1548000" cy="144000"/>
          </a:xfrm>
        </p:grpSpPr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0EA65124-8DA7-4D56-8151-9917739897A6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11BB4A48-6BAC-4C47-9E8B-AEFBCF95C587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786700F5-DD16-4E79-A590-8A2AC0EACFAB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3B764101-C54F-4A29-9BA7-139E2E9B2CC5}"/>
              </a:ext>
            </a:extLst>
          </p:cNvPr>
          <p:cNvSpPr txBox="1"/>
          <p:nvPr/>
        </p:nvSpPr>
        <p:spPr>
          <a:xfrm>
            <a:off x="9389157" y="3809095"/>
            <a:ext cx="9665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0455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86C2CD62-B7E4-4EA2-B1C6-4348901CDEE7}"/>
              </a:ext>
            </a:extLst>
          </p:cNvPr>
          <p:cNvGrpSpPr/>
          <p:nvPr/>
        </p:nvGrpSpPr>
        <p:grpSpPr>
          <a:xfrm>
            <a:off x="9167852" y="4055063"/>
            <a:ext cx="1260000" cy="144000"/>
            <a:chOff x="1258295" y="314764"/>
            <a:chExt cx="1548000" cy="144000"/>
          </a:xfrm>
        </p:grpSpPr>
        <p:cxnSp>
          <p:nvCxnSpPr>
            <p:cNvPr id="64" name="直線コネクタ 63">
              <a:extLst>
                <a:ext uri="{FF2B5EF4-FFF2-40B4-BE49-F238E27FC236}">
                  <a16:creationId xmlns:a16="http://schemas.microsoft.com/office/drawing/2014/main" id="{C4AA855A-0D98-48D2-A1CE-2BBAE9787D8C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E7B304EE-476E-4219-9A79-E22C4D20F07B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BDE81625-340C-4FB6-9C55-FEB4734BB9DC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F4DD065F-4E76-42E0-BBA9-5A3BB7438ACF}"/>
              </a:ext>
            </a:extLst>
          </p:cNvPr>
          <p:cNvSpPr txBox="1"/>
          <p:nvPr/>
        </p:nvSpPr>
        <p:spPr>
          <a:xfrm>
            <a:off x="0" y="-16419"/>
            <a:ext cx="6184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5.</a:t>
            </a:r>
            <a:endParaRPr kumimoji="1" lang="en-US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5622794E-C3C1-42D8-BB73-164D6CA0C63C}"/>
              </a:ext>
            </a:extLst>
          </p:cNvPr>
          <p:cNvSpPr txBox="1"/>
          <p:nvPr/>
        </p:nvSpPr>
        <p:spPr>
          <a:xfrm>
            <a:off x="222693" y="813037"/>
            <a:ext cx="48144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550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3" name="グループ化 72">
            <a:extLst>
              <a:ext uri="{FF2B5EF4-FFF2-40B4-BE49-F238E27FC236}">
                <a16:creationId xmlns:a16="http://schemas.microsoft.com/office/drawing/2014/main" id="{5792F364-B904-4DA7-89EF-50327220CACF}"/>
              </a:ext>
            </a:extLst>
          </p:cNvPr>
          <p:cNvGrpSpPr>
            <a:grpSpLocks noChangeAspect="1"/>
          </p:cNvGrpSpPr>
          <p:nvPr/>
        </p:nvGrpSpPr>
        <p:grpSpPr>
          <a:xfrm>
            <a:off x="288292" y="1003373"/>
            <a:ext cx="331658" cy="132851"/>
            <a:chOff x="4125724" y="5127480"/>
            <a:chExt cx="2630937" cy="1053863"/>
          </a:xfrm>
        </p:grpSpPr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D50F7DBA-0280-4F07-97D6-721B9BBA73F7}"/>
                </a:ext>
              </a:extLst>
            </p:cNvPr>
            <p:cNvSpPr/>
            <p:nvPr/>
          </p:nvSpPr>
          <p:spPr>
            <a:xfrm>
              <a:off x="4125724" y="5127480"/>
              <a:ext cx="2590384" cy="10538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75" name="グループ化 74">
              <a:extLst>
                <a:ext uri="{FF2B5EF4-FFF2-40B4-BE49-F238E27FC236}">
                  <a16:creationId xmlns:a16="http://schemas.microsoft.com/office/drawing/2014/main" id="{A8CE044F-CEEF-420E-910F-A79BD2990726}"/>
                </a:ext>
              </a:extLst>
            </p:cNvPr>
            <p:cNvGrpSpPr/>
            <p:nvPr/>
          </p:nvGrpSpPr>
          <p:grpSpPr>
            <a:xfrm>
              <a:off x="4154334" y="5204576"/>
              <a:ext cx="2602327" cy="976767"/>
              <a:chOff x="-1447800" y="3884354"/>
              <a:chExt cx="669824" cy="251413"/>
            </a:xfrm>
          </p:grpSpPr>
          <p:sp>
            <p:nvSpPr>
              <p:cNvPr id="76" name="フリーフォーム: 図形 75">
                <a:extLst>
                  <a:ext uri="{FF2B5EF4-FFF2-40B4-BE49-F238E27FC236}">
                    <a16:creationId xmlns:a16="http://schemas.microsoft.com/office/drawing/2014/main" id="{941F8A58-9611-412D-8CDC-187A9A51E9A5}"/>
                  </a:ext>
                </a:extLst>
              </p:cNvPr>
              <p:cNvSpPr/>
              <p:nvPr/>
            </p:nvSpPr>
            <p:spPr>
              <a:xfrm>
                <a:off x="-1447800" y="3884354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noFill/>
              <a:ln w="127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77" name="フリーフォーム: 図形 76">
                <a:extLst>
                  <a:ext uri="{FF2B5EF4-FFF2-40B4-BE49-F238E27FC236}">
                    <a16:creationId xmlns:a16="http://schemas.microsoft.com/office/drawing/2014/main" id="{8BC0C7E9-67C9-47E7-B744-210316B8916C}"/>
                  </a:ext>
                </a:extLst>
              </p:cNvPr>
              <p:cNvSpPr/>
              <p:nvPr/>
            </p:nvSpPr>
            <p:spPr>
              <a:xfrm>
                <a:off x="-1444726" y="3945972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</p:grpSp>
      <p:grpSp>
        <p:nvGrpSpPr>
          <p:cNvPr id="78" name="グループ化 77">
            <a:extLst>
              <a:ext uri="{FF2B5EF4-FFF2-40B4-BE49-F238E27FC236}">
                <a16:creationId xmlns:a16="http://schemas.microsoft.com/office/drawing/2014/main" id="{34235D8A-9CCA-4671-8E44-1097538F81AF}"/>
              </a:ext>
            </a:extLst>
          </p:cNvPr>
          <p:cNvGrpSpPr>
            <a:grpSpLocks noChangeAspect="1"/>
          </p:cNvGrpSpPr>
          <p:nvPr/>
        </p:nvGrpSpPr>
        <p:grpSpPr>
          <a:xfrm>
            <a:off x="2513310" y="1003373"/>
            <a:ext cx="331658" cy="132851"/>
            <a:chOff x="4125724" y="5127480"/>
            <a:chExt cx="2630937" cy="1053863"/>
          </a:xfrm>
        </p:grpSpPr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FBA8BFE2-93FF-4F85-B0FA-CC1786737886}"/>
                </a:ext>
              </a:extLst>
            </p:cNvPr>
            <p:cNvSpPr/>
            <p:nvPr/>
          </p:nvSpPr>
          <p:spPr>
            <a:xfrm>
              <a:off x="4125724" y="5127480"/>
              <a:ext cx="2590384" cy="10538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80" name="グループ化 79">
              <a:extLst>
                <a:ext uri="{FF2B5EF4-FFF2-40B4-BE49-F238E27FC236}">
                  <a16:creationId xmlns:a16="http://schemas.microsoft.com/office/drawing/2014/main" id="{1EA3CB05-29D3-4DAD-A2AA-3A2FBFB912C6}"/>
                </a:ext>
              </a:extLst>
            </p:cNvPr>
            <p:cNvGrpSpPr/>
            <p:nvPr/>
          </p:nvGrpSpPr>
          <p:grpSpPr>
            <a:xfrm>
              <a:off x="4154334" y="5204576"/>
              <a:ext cx="2602327" cy="976767"/>
              <a:chOff x="-1447800" y="3884354"/>
              <a:chExt cx="669824" cy="251413"/>
            </a:xfrm>
          </p:grpSpPr>
          <p:sp>
            <p:nvSpPr>
              <p:cNvPr id="81" name="フリーフォーム: 図形 80">
                <a:extLst>
                  <a:ext uri="{FF2B5EF4-FFF2-40B4-BE49-F238E27FC236}">
                    <a16:creationId xmlns:a16="http://schemas.microsoft.com/office/drawing/2014/main" id="{32A98001-37E5-4A24-AB57-053D49E19C47}"/>
                  </a:ext>
                </a:extLst>
              </p:cNvPr>
              <p:cNvSpPr/>
              <p:nvPr/>
            </p:nvSpPr>
            <p:spPr>
              <a:xfrm>
                <a:off x="-1447800" y="3884354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noFill/>
              <a:ln w="127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82" name="フリーフォーム: 図形 81">
                <a:extLst>
                  <a:ext uri="{FF2B5EF4-FFF2-40B4-BE49-F238E27FC236}">
                    <a16:creationId xmlns:a16="http://schemas.microsoft.com/office/drawing/2014/main" id="{ED6E1142-6F11-4DF0-A2A1-A49BD6E8DA8B}"/>
                  </a:ext>
                </a:extLst>
              </p:cNvPr>
              <p:cNvSpPr/>
              <p:nvPr/>
            </p:nvSpPr>
            <p:spPr>
              <a:xfrm>
                <a:off x="-1444726" y="3945972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</p:grp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751268E9-1637-4D69-8586-D3DC67017EE3}"/>
              </a:ext>
            </a:extLst>
          </p:cNvPr>
          <p:cNvSpPr txBox="1"/>
          <p:nvPr/>
        </p:nvSpPr>
        <p:spPr>
          <a:xfrm>
            <a:off x="2513310" y="740235"/>
            <a:ext cx="198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/>
              <a:t>・</a:t>
            </a:r>
            <a:endParaRPr kumimoji="1" lang="ja-JP" altLang="en-US" dirty="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BC058115-8398-4162-83EC-0A861D6AF358}"/>
              </a:ext>
            </a:extLst>
          </p:cNvPr>
          <p:cNvSpPr txBox="1"/>
          <p:nvPr/>
        </p:nvSpPr>
        <p:spPr>
          <a:xfrm>
            <a:off x="1034625" y="3274911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898FA2D-3A9A-4698-B60F-4C66405A1492}"/>
              </a:ext>
            </a:extLst>
          </p:cNvPr>
          <p:cNvSpPr txBox="1"/>
          <p:nvPr/>
        </p:nvSpPr>
        <p:spPr>
          <a:xfrm>
            <a:off x="2436622" y="3274911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6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FCA12823-1C84-42CC-9431-D167C6BD53F5}"/>
              </a:ext>
            </a:extLst>
          </p:cNvPr>
          <p:cNvSpPr txBox="1"/>
          <p:nvPr/>
        </p:nvSpPr>
        <p:spPr>
          <a:xfrm>
            <a:off x="4821674" y="3274911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AC8AB1EE-B0AF-461A-856E-FDDA6063CFA9}"/>
              </a:ext>
            </a:extLst>
          </p:cNvPr>
          <p:cNvSpPr txBox="1"/>
          <p:nvPr/>
        </p:nvSpPr>
        <p:spPr>
          <a:xfrm>
            <a:off x="6286454" y="3274911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6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9D16F82D-4D22-4C2B-8344-FE72239DDBB3}"/>
              </a:ext>
            </a:extLst>
          </p:cNvPr>
          <p:cNvSpPr txBox="1"/>
          <p:nvPr/>
        </p:nvSpPr>
        <p:spPr>
          <a:xfrm>
            <a:off x="8752588" y="3274911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E76659C8-6455-431A-9976-94C34CAD1EBA}"/>
              </a:ext>
            </a:extLst>
          </p:cNvPr>
          <p:cNvSpPr txBox="1"/>
          <p:nvPr/>
        </p:nvSpPr>
        <p:spPr>
          <a:xfrm>
            <a:off x="10206544" y="3274911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6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150A1876-CD01-4E10-98E9-E81AEDDBC9D8}"/>
              </a:ext>
            </a:extLst>
          </p:cNvPr>
          <p:cNvSpPr txBox="1"/>
          <p:nvPr/>
        </p:nvSpPr>
        <p:spPr>
          <a:xfrm>
            <a:off x="1093768" y="6561852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9D6933B8-D779-4AF7-9156-3B30BC15ACF6}"/>
              </a:ext>
            </a:extLst>
          </p:cNvPr>
          <p:cNvSpPr txBox="1"/>
          <p:nvPr/>
        </p:nvSpPr>
        <p:spPr>
          <a:xfrm>
            <a:off x="2518308" y="6561851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6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4099A051-16EA-4143-83DC-F72A7581831D}"/>
              </a:ext>
            </a:extLst>
          </p:cNvPr>
          <p:cNvSpPr txBox="1"/>
          <p:nvPr/>
        </p:nvSpPr>
        <p:spPr>
          <a:xfrm>
            <a:off x="4821674" y="6559499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3A8CAAF9-CC10-49EE-8E66-8EF70BC5F6D0}"/>
              </a:ext>
            </a:extLst>
          </p:cNvPr>
          <p:cNvSpPr txBox="1"/>
          <p:nvPr/>
        </p:nvSpPr>
        <p:spPr>
          <a:xfrm>
            <a:off x="6270956" y="6559498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6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2EEF15D3-77E0-4368-981B-68B1E2B8ACF6}"/>
              </a:ext>
            </a:extLst>
          </p:cNvPr>
          <p:cNvSpPr txBox="1"/>
          <p:nvPr/>
        </p:nvSpPr>
        <p:spPr>
          <a:xfrm>
            <a:off x="8744836" y="6569738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DE33C2A5-408D-4C06-835E-6AF745DB067E}"/>
              </a:ext>
            </a:extLst>
          </p:cNvPr>
          <p:cNvSpPr txBox="1"/>
          <p:nvPr/>
        </p:nvSpPr>
        <p:spPr>
          <a:xfrm>
            <a:off x="10206545" y="6561855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6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05367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" name="図 99">
            <a:extLst>
              <a:ext uri="{FF2B5EF4-FFF2-40B4-BE49-F238E27FC236}">
                <a16:creationId xmlns:a16="http://schemas.microsoft.com/office/drawing/2014/main" id="{24493B31-617A-64A6-DA98-818B2A372F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92291" y="4009827"/>
            <a:ext cx="3857079" cy="2664000"/>
          </a:xfrm>
          <a:prstGeom prst="rect">
            <a:avLst/>
          </a:prstGeom>
        </p:spPr>
      </p:pic>
      <p:pic>
        <p:nvPicPr>
          <p:cNvPr id="98" name="図 97">
            <a:extLst>
              <a:ext uri="{FF2B5EF4-FFF2-40B4-BE49-F238E27FC236}">
                <a16:creationId xmlns:a16="http://schemas.microsoft.com/office/drawing/2014/main" id="{F06653BB-F202-AFB1-73C2-31BF836B7BE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53469" y="4015203"/>
            <a:ext cx="3857079" cy="2664000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DFED3E36-7D6C-DE88-FD61-A7106A910B9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224" y="3988541"/>
            <a:ext cx="3857079" cy="2664000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9598FF21-FB12-BB61-4A08-A2E3F453B2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048486" y="691701"/>
            <a:ext cx="3857079" cy="2664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51361F8C-685D-9FD0-C317-D89C02DFBF9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60996" y="687888"/>
            <a:ext cx="3857079" cy="266400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BED90D1B-DDF7-ED1C-2F6A-01B9BC9277B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6923" y="691830"/>
            <a:ext cx="3857079" cy="26640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B63B84A-7349-4C70-B7CF-D157B26F0EBA}"/>
              </a:ext>
            </a:extLst>
          </p:cNvPr>
          <p:cNvSpPr txBox="1"/>
          <p:nvPr/>
        </p:nvSpPr>
        <p:spPr>
          <a:xfrm>
            <a:off x="0" y="360000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4890BA3-FEA6-4034-90BA-590B2D254BBC}"/>
              </a:ext>
            </a:extLst>
          </p:cNvPr>
          <p:cNvSpPr txBox="1"/>
          <p:nvPr/>
        </p:nvSpPr>
        <p:spPr>
          <a:xfrm>
            <a:off x="3670434" y="360000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164B3DB-75CB-4D9F-BA0D-DB78F95DA21F}"/>
              </a:ext>
            </a:extLst>
          </p:cNvPr>
          <p:cNvSpPr txBox="1"/>
          <p:nvPr/>
        </p:nvSpPr>
        <p:spPr>
          <a:xfrm>
            <a:off x="7766893" y="360000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B505580D-C505-4A43-8C26-B8A996156800}"/>
              </a:ext>
            </a:extLst>
          </p:cNvPr>
          <p:cNvSpPr txBox="1"/>
          <p:nvPr/>
        </p:nvSpPr>
        <p:spPr>
          <a:xfrm>
            <a:off x="1558203" y="524027"/>
            <a:ext cx="9665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7158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FFDF15C5-F7D8-4987-B7B2-C6B637BFE4AC}"/>
              </a:ext>
            </a:extLst>
          </p:cNvPr>
          <p:cNvGrpSpPr/>
          <p:nvPr/>
        </p:nvGrpSpPr>
        <p:grpSpPr>
          <a:xfrm>
            <a:off x="1336949" y="762208"/>
            <a:ext cx="1278000" cy="144000"/>
            <a:chOff x="1258295" y="314764"/>
            <a:chExt cx="1548000" cy="144000"/>
          </a:xfrm>
        </p:grpSpPr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F1D8C9EC-34E0-4E16-9F94-5A27AA5D99A4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802DF368-8485-471D-B58B-9C24DAE40190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3B2E56E8-0424-4E64-858C-C196545DAA8C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3A7ED9C-FE3A-42C1-B805-4538905D4A83}"/>
              </a:ext>
            </a:extLst>
          </p:cNvPr>
          <p:cNvSpPr txBox="1"/>
          <p:nvPr/>
        </p:nvSpPr>
        <p:spPr>
          <a:xfrm>
            <a:off x="5303539" y="524801"/>
            <a:ext cx="9665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312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F93D57A6-A47A-428F-8414-0F8CB1E80287}"/>
              </a:ext>
            </a:extLst>
          </p:cNvPr>
          <p:cNvSpPr txBox="1"/>
          <p:nvPr/>
        </p:nvSpPr>
        <p:spPr>
          <a:xfrm>
            <a:off x="9564402" y="524027"/>
            <a:ext cx="8252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4689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8F7CA05-9BDA-48EB-ACE0-7ABB36F4AD26}"/>
              </a:ext>
            </a:extLst>
          </p:cNvPr>
          <p:cNvSpPr txBox="1"/>
          <p:nvPr/>
        </p:nvSpPr>
        <p:spPr>
          <a:xfrm>
            <a:off x="0" y="3708000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F83FE6D-7E88-44AD-8785-3DC9066091C1}"/>
              </a:ext>
            </a:extLst>
          </p:cNvPr>
          <p:cNvSpPr txBox="1"/>
          <p:nvPr/>
        </p:nvSpPr>
        <p:spPr>
          <a:xfrm>
            <a:off x="3685822" y="3711680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7CFC7E2-4116-49FB-A2BF-866671300EF1}"/>
              </a:ext>
            </a:extLst>
          </p:cNvPr>
          <p:cNvSpPr txBox="1"/>
          <p:nvPr/>
        </p:nvSpPr>
        <p:spPr>
          <a:xfrm>
            <a:off x="7766893" y="3703269"/>
            <a:ext cx="381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817F5B4-49F9-4671-9A40-BAEE44693D17}"/>
              </a:ext>
            </a:extLst>
          </p:cNvPr>
          <p:cNvSpPr txBox="1"/>
          <p:nvPr/>
        </p:nvSpPr>
        <p:spPr>
          <a:xfrm>
            <a:off x="1558203" y="3758336"/>
            <a:ext cx="9665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1939</a:t>
            </a: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0549E164-8BD4-4413-B648-D8C1C9ABB313}"/>
              </a:ext>
            </a:extLst>
          </p:cNvPr>
          <p:cNvSpPr txBox="1"/>
          <p:nvPr/>
        </p:nvSpPr>
        <p:spPr>
          <a:xfrm>
            <a:off x="5308791" y="3765541"/>
            <a:ext cx="7872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7728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3B764101-C54F-4A29-9BA7-139E2E9B2CC5}"/>
              </a:ext>
            </a:extLst>
          </p:cNvPr>
          <p:cNvSpPr txBox="1"/>
          <p:nvPr/>
        </p:nvSpPr>
        <p:spPr>
          <a:xfrm>
            <a:off x="9653155" y="3757130"/>
            <a:ext cx="8049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0.1939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F4DD065F-4E76-42E0-BBA9-5A3BB7438ACF}"/>
              </a:ext>
            </a:extLst>
          </p:cNvPr>
          <p:cNvSpPr txBox="1"/>
          <p:nvPr/>
        </p:nvSpPr>
        <p:spPr>
          <a:xfrm>
            <a:off x="0" y="-15679"/>
            <a:ext cx="6184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6.</a:t>
            </a:r>
            <a:endParaRPr kumimoji="1" lang="en-US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99CB95E3-C20F-46DB-BD81-7B49981F3D3D}"/>
              </a:ext>
            </a:extLst>
          </p:cNvPr>
          <p:cNvSpPr txBox="1"/>
          <p:nvPr/>
        </p:nvSpPr>
        <p:spPr>
          <a:xfrm>
            <a:off x="8236332" y="4091946"/>
            <a:ext cx="38112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2" name="グループ化 71">
            <a:extLst>
              <a:ext uri="{FF2B5EF4-FFF2-40B4-BE49-F238E27FC236}">
                <a16:creationId xmlns:a16="http://schemas.microsoft.com/office/drawing/2014/main" id="{6D2B4CD2-106F-4F5F-896A-B629AB135B5E}"/>
              </a:ext>
            </a:extLst>
          </p:cNvPr>
          <p:cNvGrpSpPr>
            <a:grpSpLocks noChangeAspect="1"/>
          </p:cNvGrpSpPr>
          <p:nvPr/>
        </p:nvGrpSpPr>
        <p:grpSpPr>
          <a:xfrm>
            <a:off x="8309224" y="4353508"/>
            <a:ext cx="331658" cy="132851"/>
            <a:chOff x="4125724" y="5127480"/>
            <a:chExt cx="2630937" cy="1053863"/>
          </a:xfrm>
        </p:grpSpPr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5D4F51A8-78BF-4489-8483-D16F0FE0F6D3}"/>
                </a:ext>
              </a:extLst>
            </p:cNvPr>
            <p:cNvSpPr/>
            <p:nvPr/>
          </p:nvSpPr>
          <p:spPr>
            <a:xfrm>
              <a:off x="4125724" y="5127480"/>
              <a:ext cx="2590384" cy="10538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74" name="グループ化 73">
              <a:extLst>
                <a:ext uri="{FF2B5EF4-FFF2-40B4-BE49-F238E27FC236}">
                  <a16:creationId xmlns:a16="http://schemas.microsoft.com/office/drawing/2014/main" id="{5A092B6D-4A19-4A9F-B1F4-6F6F9A6A8B32}"/>
                </a:ext>
              </a:extLst>
            </p:cNvPr>
            <p:cNvGrpSpPr/>
            <p:nvPr/>
          </p:nvGrpSpPr>
          <p:grpSpPr>
            <a:xfrm>
              <a:off x="4154334" y="5204576"/>
              <a:ext cx="2602327" cy="976767"/>
              <a:chOff x="-1447800" y="3884354"/>
              <a:chExt cx="669824" cy="251413"/>
            </a:xfrm>
          </p:grpSpPr>
          <p:sp>
            <p:nvSpPr>
              <p:cNvPr id="75" name="フリーフォーム: 図形 74">
                <a:extLst>
                  <a:ext uri="{FF2B5EF4-FFF2-40B4-BE49-F238E27FC236}">
                    <a16:creationId xmlns:a16="http://schemas.microsoft.com/office/drawing/2014/main" id="{53B0E7AB-1036-4875-B5E4-6F8AE532D21A}"/>
                  </a:ext>
                </a:extLst>
              </p:cNvPr>
              <p:cNvSpPr/>
              <p:nvPr/>
            </p:nvSpPr>
            <p:spPr>
              <a:xfrm>
                <a:off x="-1447800" y="3884354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noFill/>
              <a:ln w="127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76" name="フリーフォーム: 図形 75">
                <a:extLst>
                  <a:ext uri="{FF2B5EF4-FFF2-40B4-BE49-F238E27FC236}">
                    <a16:creationId xmlns:a16="http://schemas.microsoft.com/office/drawing/2014/main" id="{586960BF-0D3B-4FDC-BE7F-DCC1E5D6FF9B}"/>
                  </a:ext>
                </a:extLst>
              </p:cNvPr>
              <p:cNvSpPr/>
              <p:nvPr/>
            </p:nvSpPr>
            <p:spPr>
              <a:xfrm>
                <a:off x="-1444726" y="3945972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</p:grp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8E01D31B-FD67-4257-9955-5C421BD1E894}"/>
              </a:ext>
            </a:extLst>
          </p:cNvPr>
          <p:cNvGrpSpPr>
            <a:grpSpLocks noChangeAspect="1"/>
          </p:cNvGrpSpPr>
          <p:nvPr/>
        </p:nvGrpSpPr>
        <p:grpSpPr>
          <a:xfrm>
            <a:off x="10521804" y="4353507"/>
            <a:ext cx="331658" cy="132851"/>
            <a:chOff x="4125724" y="5127480"/>
            <a:chExt cx="2630937" cy="1053863"/>
          </a:xfrm>
        </p:grpSpPr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3AC288AF-BB36-40CB-8799-70C185561D2A}"/>
                </a:ext>
              </a:extLst>
            </p:cNvPr>
            <p:cNvSpPr/>
            <p:nvPr/>
          </p:nvSpPr>
          <p:spPr>
            <a:xfrm>
              <a:off x="4125724" y="5127480"/>
              <a:ext cx="2590384" cy="10538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79" name="グループ化 78">
              <a:extLst>
                <a:ext uri="{FF2B5EF4-FFF2-40B4-BE49-F238E27FC236}">
                  <a16:creationId xmlns:a16="http://schemas.microsoft.com/office/drawing/2014/main" id="{3413F974-839A-4F91-9EA9-A5DD4003D87A}"/>
                </a:ext>
              </a:extLst>
            </p:cNvPr>
            <p:cNvGrpSpPr/>
            <p:nvPr/>
          </p:nvGrpSpPr>
          <p:grpSpPr>
            <a:xfrm>
              <a:off x="4154334" y="5204576"/>
              <a:ext cx="2602327" cy="976767"/>
              <a:chOff x="-1447800" y="3884354"/>
              <a:chExt cx="669824" cy="251413"/>
            </a:xfrm>
          </p:grpSpPr>
          <p:sp>
            <p:nvSpPr>
              <p:cNvPr id="80" name="フリーフォーム: 図形 79">
                <a:extLst>
                  <a:ext uri="{FF2B5EF4-FFF2-40B4-BE49-F238E27FC236}">
                    <a16:creationId xmlns:a16="http://schemas.microsoft.com/office/drawing/2014/main" id="{07E6D329-E358-40F5-B039-72DB20EBB99D}"/>
                  </a:ext>
                </a:extLst>
              </p:cNvPr>
              <p:cNvSpPr/>
              <p:nvPr/>
            </p:nvSpPr>
            <p:spPr>
              <a:xfrm>
                <a:off x="-1447800" y="3884354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noFill/>
              <a:ln w="127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81" name="フリーフォーム: 図形 80">
                <a:extLst>
                  <a:ext uri="{FF2B5EF4-FFF2-40B4-BE49-F238E27FC236}">
                    <a16:creationId xmlns:a16="http://schemas.microsoft.com/office/drawing/2014/main" id="{2DEEFD0A-221F-45F2-88B0-88FF122BC748}"/>
                  </a:ext>
                </a:extLst>
              </p:cNvPr>
              <p:cNvSpPr/>
              <p:nvPr/>
            </p:nvSpPr>
            <p:spPr>
              <a:xfrm>
                <a:off x="-1444726" y="3945972"/>
                <a:ext cx="666750" cy="189795"/>
              </a:xfrm>
              <a:custGeom>
                <a:avLst/>
                <a:gdLst>
                  <a:gd name="connsiteX0" fmla="*/ 0 w 666750"/>
                  <a:gd name="connsiteY0" fmla="*/ 12700 h 12700"/>
                  <a:gd name="connsiteX1" fmla="*/ 184150 w 666750"/>
                  <a:gd name="connsiteY1" fmla="*/ 12700 h 12700"/>
                  <a:gd name="connsiteX2" fmla="*/ 387350 w 666750"/>
                  <a:gd name="connsiteY2" fmla="*/ 12700 h 12700"/>
                  <a:gd name="connsiteX3" fmla="*/ 666750 w 666750"/>
                  <a:gd name="connsiteY3" fmla="*/ 0 h 1270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5250 h 95250"/>
                  <a:gd name="connsiteX1" fmla="*/ 184150 w 666750"/>
                  <a:gd name="connsiteY1" fmla="*/ 0 h 95250"/>
                  <a:gd name="connsiteX2" fmla="*/ 387350 w 666750"/>
                  <a:gd name="connsiteY2" fmla="*/ 95250 h 95250"/>
                  <a:gd name="connsiteX3" fmla="*/ 666750 w 666750"/>
                  <a:gd name="connsiteY3" fmla="*/ 82550 h 95250"/>
                  <a:gd name="connsiteX0" fmla="*/ 0 w 666750"/>
                  <a:gd name="connsiteY0" fmla="*/ 97095 h 185995"/>
                  <a:gd name="connsiteX1" fmla="*/ 184150 w 666750"/>
                  <a:gd name="connsiteY1" fmla="*/ 1845 h 185995"/>
                  <a:gd name="connsiteX2" fmla="*/ 431800 w 666750"/>
                  <a:gd name="connsiteY2" fmla="*/ 185995 h 185995"/>
                  <a:gd name="connsiteX3" fmla="*/ 666750 w 666750"/>
                  <a:gd name="connsiteY3" fmla="*/ 84395 h 1859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  <a:gd name="connsiteX0" fmla="*/ 0 w 666750"/>
                  <a:gd name="connsiteY0" fmla="*/ 97095 h 189795"/>
                  <a:gd name="connsiteX1" fmla="*/ 184150 w 666750"/>
                  <a:gd name="connsiteY1" fmla="*/ 1845 h 189795"/>
                  <a:gd name="connsiteX2" fmla="*/ 431800 w 666750"/>
                  <a:gd name="connsiteY2" fmla="*/ 185995 h 189795"/>
                  <a:gd name="connsiteX3" fmla="*/ 666750 w 666750"/>
                  <a:gd name="connsiteY3" fmla="*/ 84395 h 189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6750" h="189795">
                    <a:moveTo>
                      <a:pt x="0" y="97095"/>
                    </a:moveTo>
                    <a:cubicBezTo>
                      <a:pt x="61383" y="65345"/>
                      <a:pt x="112183" y="-12972"/>
                      <a:pt x="184150" y="1845"/>
                    </a:cubicBezTo>
                    <a:cubicBezTo>
                      <a:pt x="256117" y="16662"/>
                      <a:pt x="353483" y="219862"/>
                      <a:pt x="431800" y="185995"/>
                    </a:cubicBezTo>
                    <a:lnTo>
                      <a:pt x="666750" y="84395"/>
                    </a:ln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</p:grp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87EB7194-3A9F-492D-9AA4-446B76356AE6}"/>
              </a:ext>
            </a:extLst>
          </p:cNvPr>
          <p:cNvSpPr txBox="1"/>
          <p:nvPr/>
        </p:nvSpPr>
        <p:spPr>
          <a:xfrm>
            <a:off x="10489178" y="4083792"/>
            <a:ext cx="198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/>
              <a:t>・</a:t>
            </a:r>
            <a:endParaRPr kumimoji="1" lang="ja-JP" altLang="en-US" dirty="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FFF09D68-0CD7-4D1D-973E-7411E7ABFDD6}"/>
              </a:ext>
            </a:extLst>
          </p:cNvPr>
          <p:cNvSpPr txBox="1"/>
          <p:nvPr/>
        </p:nvSpPr>
        <p:spPr>
          <a:xfrm>
            <a:off x="936246" y="3144583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F9D2AA97-A861-464C-8066-49FA9B1C9027}"/>
              </a:ext>
            </a:extLst>
          </p:cNvPr>
          <p:cNvSpPr txBox="1"/>
          <p:nvPr/>
        </p:nvSpPr>
        <p:spPr>
          <a:xfrm>
            <a:off x="2369545" y="3141181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6F9F9E7D-DAF8-4AD4-98A4-0772F61A519B}"/>
              </a:ext>
            </a:extLst>
          </p:cNvPr>
          <p:cNvSpPr txBox="1"/>
          <p:nvPr/>
        </p:nvSpPr>
        <p:spPr>
          <a:xfrm>
            <a:off x="4717916" y="3141181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14911AD0-5E52-4BE8-95E2-51AF0C3E1B59}"/>
              </a:ext>
            </a:extLst>
          </p:cNvPr>
          <p:cNvSpPr txBox="1"/>
          <p:nvPr/>
        </p:nvSpPr>
        <p:spPr>
          <a:xfrm>
            <a:off x="6172521" y="3141181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CA3B9D53-DB8F-41E8-8D75-1F742BE47397}"/>
              </a:ext>
            </a:extLst>
          </p:cNvPr>
          <p:cNvSpPr txBox="1"/>
          <p:nvPr/>
        </p:nvSpPr>
        <p:spPr>
          <a:xfrm>
            <a:off x="8913688" y="3132000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4F7DE3C8-0F9C-4F95-B631-71163FE502D2}"/>
              </a:ext>
            </a:extLst>
          </p:cNvPr>
          <p:cNvSpPr txBox="1"/>
          <p:nvPr/>
        </p:nvSpPr>
        <p:spPr>
          <a:xfrm>
            <a:off x="10359273" y="3141768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33A0ADCF-F35D-4D29-A45A-D0D747577C39}"/>
              </a:ext>
            </a:extLst>
          </p:cNvPr>
          <p:cNvSpPr txBox="1"/>
          <p:nvPr/>
        </p:nvSpPr>
        <p:spPr>
          <a:xfrm>
            <a:off x="936245" y="6432982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9CBA042D-A503-4D0E-8807-C54D09660233}"/>
              </a:ext>
            </a:extLst>
          </p:cNvPr>
          <p:cNvSpPr txBox="1"/>
          <p:nvPr/>
        </p:nvSpPr>
        <p:spPr>
          <a:xfrm>
            <a:off x="2412177" y="6432982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7CC5DA2D-33CF-41AA-ABD7-E2698AECC52B}"/>
              </a:ext>
            </a:extLst>
          </p:cNvPr>
          <p:cNvSpPr txBox="1"/>
          <p:nvPr/>
        </p:nvSpPr>
        <p:spPr>
          <a:xfrm>
            <a:off x="4616904" y="6432982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F03F083C-0490-4D27-A3B8-6FB43E85C453}"/>
              </a:ext>
            </a:extLst>
          </p:cNvPr>
          <p:cNvSpPr txBox="1"/>
          <p:nvPr/>
        </p:nvSpPr>
        <p:spPr>
          <a:xfrm>
            <a:off x="6032819" y="6427606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286A4DBD-63AD-41ED-9E5B-E664BEA6B694}"/>
              </a:ext>
            </a:extLst>
          </p:cNvPr>
          <p:cNvSpPr txBox="1"/>
          <p:nvPr/>
        </p:nvSpPr>
        <p:spPr>
          <a:xfrm>
            <a:off x="8946897" y="6422737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74B28BD4-53C0-48B5-B842-1AD26549B6A5}"/>
              </a:ext>
            </a:extLst>
          </p:cNvPr>
          <p:cNvSpPr txBox="1"/>
          <p:nvPr/>
        </p:nvSpPr>
        <p:spPr>
          <a:xfrm>
            <a:off x="10467348" y="6432982"/>
            <a:ext cx="57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C8A7B2B2-FC0A-DFD2-121C-0B3DC9743A8B}"/>
              </a:ext>
            </a:extLst>
          </p:cNvPr>
          <p:cNvGrpSpPr/>
          <p:nvPr/>
        </p:nvGrpSpPr>
        <p:grpSpPr>
          <a:xfrm>
            <a:off x="5043009" y="771957"/>
            <a:ext cx="1278000" cy="144000"/>
            <a:chOff x="1258295" y="314764"/>
            <a:chExt cx="1548000" cy="144000"/>
          </a:xfrm>
        </p:grpSpPr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BD92228A-3ACE-8AB5-2ECF-201484CE047B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35D2D59E-B1D8-05A2-1DAC-7278223B2DEE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70605AF4-20FC-F890-79BF-BDB2BB062A8F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02243151-9291-32CF-004A-E5D2AF822CAE}"/>
              </a:ext>
            </a:extLst>
          </p:cNvPr>
          <p:cNvGrpSpPr/>
          <p:nvPr/>
        </p:nvGrpSpPr>
        <p:grpSpPr>
          <a:xfrm>
            <a:off x="9338025" y="762208"/>
            <a:ext cx="1278000" cy="144000"/>
            <a:chOff x="1258295" y="314764"/>
            <a:chExt cx="1548000" cy="144000"/>
          </a:xfrm>
        </p:grpSpPr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DF2EF5EF-E051-C67B-2B51-03218B220BC1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2AFF82D0-1C3F-F648-0863-6CAE1252FDE3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9E6A119B-F2B5-BCAF-8E25-89DC408C3FDC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449F43E8-4D06-AB46-0ADA-8641E922AD2D}"/>
              </a:ext>
            </a:extLst>
          </p:cNvPr>
          <p:cNvGrpSpPr/>
          <p:nvPr/>
        </p:nvGrpSpPr>
        <p:grpSpPr>
          <a:xfrm>
            <a:off x="1336949" y="4020113"/>
            <a:ext cx="1278000" cy="144000"/>
            <a:chOff x="1258295" y="314764"/>
            <a:chExt cx="1548000" cy="144000"/>
          </a:xfrm>
        </p:grpSpPr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5739A435-2321-E4D0-0C46-0633D94690E4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736B1DEB-28CC-AACE-4142-124931F98348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36C4AE2A-F7C3-86FF-A314-252885BD8899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DBCE7F0B-4442-C382-3CD8-78E2B47AFD1A}"/>
              </a:ext>
            </a:extLst>
          </p:cNvPr>
          <p:cNvGrpSpPr/>
          <p:nvPr/>
        </p:nvGrpSpPr>
        <p:grpSpPr>
          <a:xfrm>
            <a:off x="5029791" y="4019946"/>
            <a:ext cx="1278000" cy="144000"/>
            <a:chOff x="1258295" y="314764"/>
            <a:chExt cx="1548000" cy="144000"/>
          </a:xfrm>
        </p:grpSpPr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6CF48600-00E6-33E3-438A-DFB5D9E44ABD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4E16D5C5-AB72-9C8D-4E89-066A491BE483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91">
              <a:extLst>
                <a:ext uri="{FF2B5EF4-FFF2-40B4-BE49-F238E27FC236}">
                  <a16:creationId xmlns:a16="http://schemas.microsoft.com/office/drawing/2014/main" id="{422F2FEB-06FE-F227-9AB6-E410E238E79D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3" name="グループ化 92">
            <a:extLst>
              <a:ext uri="{FF2B5EF4-FFF2-40B4-BE49-F238E27FC236}">
                <a16:creationId xmlns:a16="http://schemas.microsoft.com/office/drawing/2014/main" id="{DB52D25A-4253-0AC2-2343-D54D75A363CD}"/>
              </a:ext>
            </a:extLst>
          </p:cNvPr>
          <p:cNvGrpSpPr/>
          <p:nvPr/>
        </p:nvGrpSpPr>
        <p:grpSpPr>
          <a:xfrm>
            <a:off x="9481831" y="4032347"/>
            <a:ext cx="1278000" cy="144000"/>
            <a:chOff x="1258295" y="314764"/>
            <a:chExt cx="1548000" cy="144000"/>
          </a:xfrm>
        </p:grpSpPr>
        <p:cxnSp>
          <p:nvCxnSpPr>
            <p:cNvPr id="94" name="直線コネクタ 93">
              <a:extLst>
                <a:ext uri="{FF2B5EF4-FFF2-40B4-BE49-F238E27FC236}">
                  <a16:creationId xmlns:a16="http://schemas.microsoft.com/office/drawing/2014/main" id="{E369F93A-AD29-AC31-F91F-61CBF345B21C}"/>
                </a:ext>
              </a:extLst>
            </p:cNvPr>
            <p:cNvCxnSpPr/>
            <p:nvPr/>
          </p:nvCxnSpPr>
          <p:spPr>
            <a:xfrm>
              <a:off x="1258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1F6EFDCD-6E56-07FF-6599-F0A28DAD46D9}"/>
                </a:ext>
              </a:extLst>
            </p:cNvPr>
            <p:cNvCxnSpPr/>
            <p:nvPr/>
          </p:nvCxnSpPr>
          <p:spPr>
            <a:xfrm>
              <a:off x="2806295" y="31476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1F0F43D4-4498-E762-0CC6-7EFDFF9E02CC}"/>
                </a:ext>
              </a:extLst>
            </p:cNvPr>
            <p:cNvCxnSpPr/>
            <p:nvPr/>
          </p:nvCxnSpPr>
          <p:spPr>
            <a:xfrm>
              <a:off x="1258295" y="314764"/>
              <a:ext cx="15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715030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015</TotalTime>
  <Words>484</Words>
  <Application>Microsoft Office PowerPoint</Application>
  <PresentationFormat>ワイド画面</PresentationFormat>
  <Paragraphs>139</Paragraphs>
  <Slides>6</Slides>
  <Notes>6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0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 Miyashita</dc:creator>
  <cp:lastModifiedBy>宮下　優</cp:lastModifiedBy>
  <cp:revision>363</cp:revision>
  <cp:lastPrinted>2021-02-20T00:27:44Z</cp:lastPrinted>
  <dcterms:created xsi:type="dcterms:W3CDTF">2020-12-24T07:47:28Z</dcterms:created>
  <dcterms:modified xsi:type="dcterms:W3CDTF">2023-06-26T15:27:02Z</dcterms:modified>
</cp:coreProperties>
</file>